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56" r:id="rId2"/>
    <p:sldId id="263" r:id="rId3"/>
    <p:sldId id="257" r:id="rId4"/>
    <p:sldId id="264" r:id="rId5"/>
    <p:sldId id="258" r:id="rId6"/>
    <p:sldId id="265" r:id="rId7"/>
    <p:sldId id="259" r:id="rId8"/>
    <p:sldId id="260" r:id="rId9"/>
    <p:sldId id="261" r:id="rId10"/>
    <p:sldId id="262" r:id="rId11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384" y="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4DD1EB-5F46-4BEA-9579-8593801DA026}" type="datetimeFigureOut">
              <a:rPr lang="zh-CN" altLang="en-US" smtClean="0"/>
              <a:t>2020/11/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9D67DB8-1216-466E-8E5F-DB2F141749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320775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9D67DB8-1216-466E-8E5F-DB2F141749F6}" type="slidenum">
              <a:rPr lang="zh-CN" altLang="en-US" smtClean="0"/>
              <a:t>10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56919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CDA57-65FD-46CB-BFB2-95A107B0F77A}" type="datetimeFigureOut">
              <a:rPr lang="zh-CN" altLang="en-US" smtClean="0"/>
              <a:t>2020/11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79EA9-91F1-44E7-8247-5C49CFEDBF6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74628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CDA57-65FD-46CB-BFB2-95A107B0F77A}" type="datetimeFigureOut">
              <a:rPr lang="zh-CN" altLang="en-US" smtClean="0"/>
              <a:t>2020/11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79EA9-91F1-44E7-8247-5C49CFEDBF6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87466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CDA57-65FD-46CB-BFB2-95A107B0F77A}" type="datetimeFigureOut">
              <a:rPr lang="zh-CN" altLang="en-US" smtClean="0"/>
              <a:t>2020/11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79EA9-91F1-44E7-8247-5C49CFEDBF6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02516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CDA57-65FD-46CB-BFB2-95A107B0F77A}" type="datetimeFigureOut">
              <a:rPr lang="zh-CN" altLang="en-US" smtClean="0"/>
              <a:t>2020/11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79EA9-91F1-44E7-8247-5C49CFEDBF6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931626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CDA57-65FD-46CB-BFB2-95A107B0F77A}" type="datetimeFigureOut">
              <a:rPr lang="zh-CN" altLang="en-US" smtClean="0"/>
              <a:t>2020/11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79EA9-91F1-44E7-8247-5C49CFEDBF6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50670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CDA57-65FD-46CB-BFB2-95A107B0F77A}" type="datetimeFigureOut">
              <a:rPr lang="zh-CN" altLang="en-US" smtClean="0"/>
              <a:t>2020/11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79EA9-91F1-44E7-8247-5C49CFEDBF6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22680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CDA57-65FD-46CB-BFB2-95A107B0F77A}" type="datetimeFigureOut">
              <a:rPr lang="zh-CN" altLang="en-US" smtClean="0"/>
              <a:t>2020/11/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79EA9-91F1-44E7-8247-5C49CFEDBF6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28923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CDA57-65FD-46CB-BFB2-95A107B0F77A}" type="datetimeFigureOut">
              <a:rPr lang="zh-CN" altLang="en-US" smtClean="0"/>
              <a:t>2020/11/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79EA9-91F1-44E7-8247-5C49CFEDBF6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92402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CDA57-65FD-46CB-BFB2-95A107B0F77A}" type="datetimeFigureOut">
              <a:rPr lang="zh-CN" altLang="en-US" smtClean="0"/>
              <a:t>2020/11/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79EA9-91F1-44E7-8247-5C49CFEDBF6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15258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CDA57-65FD-46CB-BFB2-95A107B0F77A}" type="datetimeFigureOut">
              <a:rPr lang="zh-CN" altLang="en-US" smtClean="0"/>
              <a:t>2020/11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79EA9-91F1-44E7-8247-5C49CFEDBF6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67325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CDA57-65FD-46CB-BFB2-95A107B0F77A}" type="datetimeFigureOut">
              <a:rPr lang="zh-CN" altLang="en-US" smtClean="0"/>
              <a:t>2020/11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79EA9-91F1-44E7-8247-5C49CFEDBF6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67620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4CDA57-65FD-46CB-BFB2-95A107B0F77A}" type="datetimeFigureOut">
              <a:rPr lang="zh-CN" altLang="en-US" smtClean="0"/>
              <a:t>2020/11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979EA9-91F1-44E7-8247-5C49CFEDBF6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11277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2.png"/><Relationship Id="rId13" Type="http://schemas.openxmlformats.org/officeDocument/2006/relationships/image" Target="../media/image167.png"/><Relationship Id="rId3" Type="http://schemas.openxmlformats.org/officeDocument/2006/relationships/image" Target="../media/image157.png"/><Relationship Id="rId7" Type="http://schemas.openxmlformats.org/officeDocument/2006/relationships/image" Target="../media/image161.png"/><Relationship Id="rId12" Type="http://schemas.openxmlformats.org/officeDocument/2006/relationships/image" Target="../media/image166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7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0.png"/><Relationship Id="rId11" Type="http://schemas.openxmlformats.org/officeDocument/2006/relationships/image" Target="../media/image165.png"/><Relationship Id="rId5" Type="http://schemas.openxmlformats.org/officeDocument/2006/relationships/image" Target="../media/image159.png"/><Relationship Id="rId15" Type="http://schemas.openxmlformats.org/officeDocument/2006/relationships/image" Target="../media/image169.png"/><Relationship Id="rId10" Type="http://schemas.openxmlformats.org/officeDocument/2006/relationships/image" Target="../media/image164.png"/><Relationship Id="rId4" Type="http://schemas.openxmlformats.org/officeDocument/2006/relationships/image" Target="../media/image158.png"/><Relationship Id="rId9" Type="http://schemas.openxmlformats.org/officeDocument/2006/relationships/image" Target="../media/image163.png"/><Relationship Id="rId14" Type="http://schemas.openxmlformats.org/officeDocument/2006/relationships/image" Target="../media/image16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png"/><Relationship Id="rId13" Type="http://schemas.openxmlformats.org/officeDocument/2006/relationships/image" Target="../media/image36.png"/><Relationship Id="rId18" Type="http://schemas.openxmlformats.org/officeDocument/2006/relationships/image" Target="../media/image41.png"/><Relationship Id="rId3" Type="http://schemas.openxmlformats.org/officeDocument/2006/relationships/image" Target="../media/image26.png"/><Relationship Id="rId21" Type="http://schemas.openxmlformats.org/officeDocument/2006/relationships/image" Target="../media/image44.png"/><Relationship Id="rId7" Type="http://schemas.openxmlformats.org/officeDocument/2006/relationships/image" Target="../media/image30.png"/><Relationship Id="rId12" Type="http://schemas.openxmlformats.org/officeDocument/2006/relationships/image" Target="../media/image35.png"/><Relationship Id="rId17" Type="http://schemas.openxmlformats.org/officeDocument/2006/relationships/image" Target="../media/image40.png"/><Relationship Id="rId25" Type="http://schemas.openxmlformats.org/officeDocument/2006/relationships/image" Target="../media/image48.png"/><Relationship Id="rId2" Type="http://schemas.openxmlformats.org/officeDocument/2006/relationships/image" Target="../media/image25.png"/><Relationship Id="rId16" Type="http://schemas.openxmlformats.org/officeDocument/2006/relationships/image" Target="../media/image39.png"/><Relationship Id="rId20" Type="http://schemas.openxmlformats.org/officeDocument/2006/relationships/image" Target="../media/image4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png"/><Relationship Id="rId11" Type="http://schemas.openxmlformats.org/officeDocument/2006/relationships/image" Target="../media/image34.png"/><Relationship Id="rId24" Type="http://schemas.openxmlformats.org/officeDocument/2006/relationships/image" Target="../media/image47.png"/><Relationship Id="rId5" Type="http://schemas.openxmlformats.org/officeDocument/2006/relationships/image" Target="../media/image28.png"/><Relationship Id="rId15" Type="http://schemas.openxmlformats.org/officeDocument/2006/relationships/image" Target="../media/image38.png"/><Relationship Id="rId23" Type="http://schemas.openxmlformats.org/officeDocument/2006/relationships/image" Target="../media/image46.png"/><Relationship Id="rId10" Type="http://schemas.openxmlformats.org/officeDocument/2006/relationships/image" Target="../media/image33.png"/><Relationship Id="rId19" Type="http://schemas.openxmlformats.org/officeDocument/2006/relationships/image" Target="../media/image42.png"/><Relationship Id="rId4" Type="http://schemas.openxmlformats.org/officeDocument/2006/relationships/image" Target="../media/image27.png"/><Relationship Id="rId9" Type="http://schemas.openxmlformats.org/officeDocument/2006/relationships/image" Target="../media/image32.png"/><Relationship Id="rId14" Type="http://schemas.openxmlformats.org/officeDocument/2006/relationships/image" Target="../media/image37.png"/><Relationship Id="rId22" Type="http://schemas.openxmlformats.org/officeDocument/2006/relationships/image" Target="../media/image45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55.png"/><Relationship Id="rId13" Type="http://schemas.openxmlformats.org/officeDocument/2006/relationships/image" Target="../media/image60.png"/><Relationship Id="rId18" Type="http://schemas.openxmlformats.org/officeDocument/2006/relationships/image" Target="../media/image65.png"/><Relationship Id="rId3" Type="http://schemas.openxmlformats.org/officeDocument/2006/relationships/image" Target="../media/image50.png"/><Relationship Id="rId21" Type="http://schemas.openxmlformats.org/officeDocument/2006/relationships/image" Target="../media/image68.png"/><Relationship Id="rId7" Type="http://schemas.openxmlformats.org/officeDocument/2006/relationships/image" Target="../media/image54.png"/><Relationship Id="rId12" Type="http://schemas.openxmlformats.org/officeDocument/2006/relationships/image" Target="../media/image59.png"/><Relationship Id="rId17" Type="http://schemas.openxmlformats.org/officeDocument/2006/relationships/image" Target="../media/image64.png"/><Relationship Id="rId25" Type="http://schemas.openxmlformats.org/officeDocument/2006/relationships/image" Target="../media/image72.png"/><Relationship Id="rId2" Type="http://schemas.openxmlformats.org/officeDocument/2006/relationships/image" Target="../media/image49.png"/><Relationship Id="rId16" Type="http://schemas.openxmlformats.org/officeDocument/2006/relationships/image" Target="../media/image63.png"/><Relationship Id="rId20" Type="http://schemas.openxmlformats.org/officeDocument/2006/relationships/image" Target="../media/image6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3.png"/><Relationship Id="rId11" Type="http://schemas.openxmlformats.org/officeDocument/2006/relationships/image" Target="../media/image58.png"/><Relationship Id="rId24" Type="http://schemas.openxmlformats.org/officeDocument/2006/relationships/image" Target="../media/image71.png"/><Relationship Id="rId5" Type="http://schemas.openxmlformats.org/officeDocument/2006/relationships/image" Target="../media/image52.png"/><Relationship Id="rId15" Type="http://schemas.openxmlformats.org/officeDocument/2006/relationships/image" Target="../media/image62.png"/><Relationship Id="rId23" Type="http://schemas.openxmlformats.org/officeDocument/2006/relationships/image" Target="../media/image70.png"/><Relationship Id="rId10" Type="http://schemas.openxmlformats.org/officeDocument/2006/relationships/image" Target="../media/image57.png"/><Relationship Id="rId19" Type="http://schemas.openxmlformats.org/officeDocument/2006/relationships/image" Target="../media/image66.png"/><Relationship Id="rId4" Type="http://schemas.openxmlformats.org/officeDocument/2006/relationships/image" Target="../media/image51.png"/><Relationship Id="rId9" Type="http://schemas.openxmlformats.org/officeDocument/2006/relationships/image" Target="../media/image56.png"/><Relationship Id="rId14" Type="http://schemas.openxmlformats.org/officeDocument/2006/relationships/image" Target="../media/image61.png"/><Relationship Id="rId22" Type="http://schemas.openxmlformats.org/officeDocument/2006/relationships/image" Target="../media/image69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79.png"/><Relationship Id="rId13" Type="http://schemas.openxmlformats.org/officeDocument/2006/relationships/image" Target="../media/image84.png"/><Relationship Id="rId18" Type="http://schemas.openxmlformats.org/officeDocument/2006/relationships/image" Target="../media/image89.png"/><Relationship Id="rId3" Type="http://schemas.openxmlformats.org/officeDocument/2006/relationships/image" Target="../media/image74.png"/><Relationship Id="rId21" Type="http://schemas.openxmlformats.org/officeDocument/2006/relationships/image" Target="../media/image92.png"/><Relationship Id="rId7" Type="http://schemas.openxmlformats.org/officeDocument/2006/relationships/image" Target="../media/image78.png"/><Relationship Id="rId12" Type="http://schemas.openxmlformats.org/officeDocument/2006/relationships/image" Target="../media/image83.png"/><Relationship Id="rId17" Type="http://schemas.openxmlformats.org/officeDocument/2006/relationships/image" Target="../media/image88.png"/><Relationship Id="rId25" Type="http://schemas.openxmlformats.org/officeDocument/2006/relationships/image" Target="../media/image96.png"/><Relationship Id="rId2" Type="http://schemas.openxmlformats.org/officeDocument/2006/relationships/image" Target="../media/image73.png"/><Relationship Id="rId16" Type="http://schemas.openxmlformats.org/officeDocument/2006/relationships/image" Target="../media/image87.png"/><Relationship Id="rId20" Type="http://schemas.openxmlformats.org/officeDocument/2006/relationships/image" Target="../media/image9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7.png"/><Relationship Id="rId11" Type="http://schemas.openxmlformats.org/officeDocument/2006/relationships/image" Target="../media/image82.png"/><Relationship Id="rId24" Type="http://schemas.openxmlformats.org/officeDocument/2006/relationships/image" Target="../media/image95.png"/><Relationship Id="rId5" Type="http://schemas.openxmlformats.org/officeDocument/2006/relationships/image" Target="../media/image76.png"/><Relationship Id="rId15" Type="http://schemas.openxmlformats.org/officeDocument/2006/relationships/image" Target="../media/image86.png"/><Relationship Id="rId23" Type="http://schemas.openxmlformats.org/officeDocument/2006/relationships/image" Target="../media/image94.png"/><Relationship Id="rId10" Type="http://schemas.openxmlformats.org/officeDocument/2006/relationships/image" Target="../media/image81.png"/><Relationship Id="rId19" Type="http://schemas.openxmlformats.org/officeDocument/2006/relationships/image" Target="../media/image90.png"/><Relationship Id="rId4" Type="http://schemas.openxmlformats.org/officeDocument/2006/relationships/image" Target="../media/image75.png"/><Relationship Id="rId9" Type="http://schemas.openxmlformats.org/officeDocument/2006/relationships/image" Target="../media/image80.png"/><Relationship Id="rId14" Type="http://schemas.openxmlformats.org/officeDocument/2006/relationships/image" Target="../media/image85.png"/><Relationship Id="rId22" Type="http://schemas.openxmlformats.org/officeDocument/2006/relationships/image" Target="../media/image93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3.png"/><Relationship Id="rId13" Type="http://schemas.openxmlformats.org/officeDocument/2006/relationships/image" Target="../media/image108.png"/><Relationship Id="rId3" Type="http://schemas.openxmlformats.org/officeDocument/2006/relationships/image" Target="../media/image98.png"/><Relationship Id="rId7" Type="http://schemas.openxmlformats.org/officeDocument/2006/relationships/image" Target="../media/image102.png"/><Relationship Id="rId12" Type="http://schemas.openxmlformats.org/officeDocument/2006/relationships/image" Target="../media/image107.png"/><Relationship Id="rId17" Type="http://schemas.openxmlformats.org/officeDocument/2006/relationships/image" Target="../media/image112.png"/><Relationship Id="rId2" Type="http://schemas.openxmlformats.org/officeDocument/2006/relationships/image" Target="../media/image97.png"/><Relationship Id="rId16" Type="http://schemas.openxmlformats.org/officeDocument/2006/relationships/image" Target="../media/image11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1.png"/><Relationship Id="rId11" Type="http://schemas.openxmlformats.org/officeDocument/2006/relationships/image" Target="../media/image106.png"/><Relationship Id="rId5" Type="http://schemas.openxmlformats.org/officeDocument/2006/relationships/image" Target="../media/image100.png"/><Relationship Id="rId15" Type="http://schemas.openxmlformats.org/officeDocument/2006/relationships/image" Target="../media/image110.png"/><Relationship Id="rId10" Type="http://schemas.openxmlformats.org/officeDocument/2006/relationships/image" Target="../media/image105.png"/><Relationship Id="rId4" Type="http://schemas.openxmlformats.org/officeDocument/2006/relationships/image" Target="../media/image99.png"/><Relationship Id="rId9" Type="http://schemas.openxmlformats.org/officeDocument/2006/relationships/image" Target="../media/image104.png"/><Relationship Id="rId14" Type="http://schemas.openxmlformats.org/officeDocument/2006/relationships/image" Target="../media/image109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9.png"/><Relationship Id="rId3" Type="http://schemas.openxmlformats.org/officeDocument/2006/relationships/image" Target="../media/image114.png"/><Relationship Id="rId7" Type="http://schemas.openxmlformats.org/officeDocument/2006/relationships/image" Target="../media/image118.png"/><Relationship Id="rId2" Type="http://schemas.openxmlformats.org/officeDocument/2006/relationships/image" Target="../media/image1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7.png"/><Relationship Id="rId5" Type="http://schemas.openxmlformats.org/officeDocument/2006/relationships/image" Target="../media/image116.png"/><Relationship Id="rId4" Type="http://schemas.openxmlformats.org/officeDocument/2006/relationships/image" Target="../media/image115.png"/><Relationship Id="rId9" Type="http://schemas.openxmlformats.org/officeDocument/2006/relationships/image" Target="../media/image120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7.png"/><Relationship Id="rId13" Type="http://schemas.openxmlformats.org/officeDocument/2006/relationships/image" Target="../media/image132.png"/><Relationship Id="rId3" Type="http://schemas.openxmlformats.org/officeDocument/2006/relationships/image" Target="../media/image122.png"/><Relationship Id="rId7" Type="http://schemas.openxmlformats.org/officeDocument/2006/relationships/image" Target="../media/image126.png"/><Relationship Id="rId12" Type="http://schemas.openxmlformats.org/officeDocument/2006/relationships/image" Target="../media/image131.png"/><Relationship Id="rId2" Type="http://schemas.openxmlformats.org/officeDocument/2006/relationships/image" Target="../media/image12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5.png"/><Relationship Id="rId11" Type="http://schemas.openxmlformats.org/officeDocument/2006/relationships/image" Target="../media/image130.png"/><Relationship Id="rId5" Type="http://schemas.openxmlformats.org/officeDocument/2006/relationships/image" Target="../media/image124.png"/><Relationship Id="rId10" Type="http://schemas.openxmlformats.org/officeDocument/2006/relationships/image" Target="../media/image129.png"/><Relationship Id="rId4" Type="http://schemas.openxmlformats.org/officeDocument/2006/relationships/image" Target="../media/image123.png"/><Relationship Id="rId9" Type="http://schemas.openxmlformats.org/officeDocument/2006/relationships/image" Target="../media/image128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9.png"/><Relationship Id="rId13" Type="http://schemas.openxmlformats.org/officeDocument/2006/relationships/image" Target="../media/image144.png"/><Relationship Id="rId3" Type="http://schemas.openxmlformats.org/officeDocument/2006/relationships/image" Target="../media/image134.png"/><Relationship Id="rId7" Type="http://schemas.openxmlformats.org/officeDocument/2006/relationships/image" Target="../media/image138.png"/><Relationship Id="rId12" Type="http://schemas.openxmlformats.org/officeDocument/2006/relationships/image" Target="../media/image143.png"/><Relationship Id="rId2" Type="http://schemas.openxmlformats.org/officeDocument/2006/relationships/image" Target="../media/image13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7.png"/><Relationship Id="rId11" Type="http://schemas.openxmlformats.org/officeDocument/2006/relationships/image" Target="../media/image142.png"/><Relationship Id="rId5" Type="http://schemas.openxmlformats.org/officeDocument/2006/relationships/image" Target="../media/image136.png"/><Relationship Id="rId10" Type="http://schemas.openxmlformats.org/officeDocument/2006/relationships/image" Target="../media/image141.png"/><Relationship Id="rId4" Type="http://schemas.openxmlformats.org/officeDocument/2006/relationships/image" Target="../media/image135.png"/><Relationship Id="rId9" Type="http://schemas.openxmlformats.org/officeDocument/2006/relationships/image" Target="../media/image140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1.png"/><Relationship Id="rId13" Type="http://schemas.openxmlformats.org/officeDocument/2006/relationships/image" Target="../media/image156.png"/><Relationship Id="rId3" Type="http://schemas.openxmlformats.org/officeDocument/2006/relationships/image" Target="../media/image146.png"/><Relationship Id="rId7" Type="http://schemas.openxmlformats.org/officeDocument/2006/relationships/image" Target="../media/image150.png"/><Relationship Id="rId12" Type="http://schemas.openxmlformats.org/officeDocument/2006/relationships/image" Target="../media/image155.png"/><Relationship Id="rId2" Type="http://schemas.openxmlformats.org/officeDocument/2006/relationships/image" Target="../media/image14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9.png"/><Relationship Id="rId11" Type="http://schemas.openxmlformats.org/officeDocument/2006/relationships/image" Target="../media/image154.png"/><Relationship Id="rId5" Type="http://schemas.openxmlformats.org/officeDocument/2006/relationships/image" Target="../media/image148.png"/><Relationship Id="rId10" Type="http://schemas.openxmlformats.org/officeDocument/2006/relationships/image" Target="../media/image153.png"/><Relationship Id="rId4" Type="http://schemas.openxmlformats.org/officeDocument/2006/relationships/image" Target="../media/image147.png"/><Relationship Id="rId9" Type="http://schemas.openxmlformats.org/officeDocument/2006/relationships/image" Target="../media/image15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332656" y="407205"/>
            <a:ext cx="5832648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 smtClean="0"/>
              <a:t>Original images for all relevant western blots in Figure 2C</a:t>
            </a:r>
            <a:endParaRPr lang="zh-CN" altLang="en-US" sz="1600" dirty="0"/>
          </a:p>
        </p:txBody>
      </p:sp>
      <p:graphicFrame>
        <p:nvGraphicFramePr>
          <p:cNvPr id="5" name="表格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2942323"/>
              </p:ext>
            </p:extLst>
          </p:nvPr>
        </p:nvGraphicFramePr>
        <p:xfrm>
          <a:off x="980728" y="1208584"/>
          <a:ext cx="4536000" cy="4267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24000"/>
                <a:gridCol w="324000"/>
                <a:gridCol w="324000"/>
                <a:gridCol w="324000"/>
                <a:gridCol w="324000"/>
                <a:gridCol w="324000"/>
                <a:gridCol w="324000"/>
                <a:gridCol w="324000"/>
                <a:gridCol w="324000"/>
                <a:gridCol w="324000"/>
                <a:gridCol w="324000"/>
                <a:gridCol w="324000"/>
                <a:gridCol w="324000"/>
                <a:gridCol w="324000"/>
              </a:tblGrid>
              <a:tr h="180000">
                <a:tc gridSpan="4"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latin typeface="+mn-lt"/>
                          <a:ea typeface="+mn-ea"/>
                          <a:cs typeface="+mn-cs"/>
                        </a:rPr>
                        <a:t>RKO</a:t>
                      </a:r>
                      <a:endParaRPr lang="zh-CN" altLang="en-US" sz="8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8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/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latin typeface="+mn-lt"/>
                          <a:ea typeface="+mn-ea"/>
                          <a:cs typeface="+mn-cs"/>
                        </a:rPr>
                        <a:t>HCT116</a:t>
                      </a:r>
                      <a:endParaRPr lang="zh-CN" altLang="en-US" sz="8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8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/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latin typeface="+mn-lt"/>
                          <a:ea typeface="+mn-ea"/>
                          <a:cs typeface="+mn-cs"/>
                        </a:rPr>
                        <a:t>DLD-1</a:t>
                      </a:r>
                      <a:endParaRPr lang="zh-CN" altLang="en-US" sz="8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</a:tr>
              <a:tr h="18000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/>
                        <a:t>C</a:t>
                      </a:r>
                      <a:endParaRPr lang="zh-CN" altLang="en-US" sz="8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latin typeface="+mn-lt"/>
                          <a:ea typeface="+mn-ea"/>
                          <a:cs typeface="+mn-cs"/>
                        </a:rPr>
                        <a:t>5</a:t>
                      </a:r>
                      <a:endParaRPr lang="zh-CN" altLang="en-US" sz="8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latin typeface="+mn-lt"/>
                          <a:ea typeface="+mn-ea"/>
                          <a:cs typeface="+mn-cs"/>
                        </a:rPr>
                        <a:t>7.5</a:t>
                      </a:r>
                      <a:endParaRPr lang="zh-CN" altLang="en-US" sz="8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latin typeface="+mn-lt"/>
                          <a:ea typeface="+mn-ea"/>
                          <a:cs typeface="+mn-cs"/>
                        </a:rPr>
                        <a:t>10</a:t>
                      </a:r>
                      <a:endParaRPr lang="zh-CN" altLang="en-US" sz="8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8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/>
                        <a:t>C</a:t>
                      </a:r>
                      <a:endParaRPr lang="zh-CN" altLang="en-US" sz="8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latin typeface="+mn-lt"/>
                          <a:ea typeface="+mn-ea"/>
                          <a:cs typeface="+mn-cs"/>
                        </a:rPr>
                        <a:t>5</a:t>
                      </a:r>
                      <a:endParaRPr lang="zh-CN" altLang="en-US" sz="8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latin typeface="+mn-lt"/>
                          <a:ea typeface="+mn-ea"/>
                          <a:cs typeface="+mn-cs"/>
                        </a:rPr>
                        <a:t>7.5</a:t>
                      </a:r>
                      <a:endParaRPr lang="zh-CN" altLang="en-US" sz="8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latin typeface="+mn-lt"/>
                          <a:ea typeface="+mn-ea"/>
                          <a:cs typeface="+mn-cs"/>
                        </a:rPr>
                        <a:t>10</a:t>
                      </a:r>
                      <a:endParaRPr lang="zh-CN" altLang="en-US" sz="8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8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/>
                        <a:t>C</a:t>
                      </a:r>
                      <a:endParaRPr lang="zh-CN" altLang="en-US" sz="8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latin typeface="+mn-lt"/>
                          <a:ea typeface="+mn-ea"/>
                          <a:cs typeface="+mn-cs"/>
                        </a:rPr>
                        <a:t>5</a:t>
                      </a:r>
                      <a:endParaRPr lang="zh-CN" altLang="en-US" sz="8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latin typeface="+mn-lt"/>
                          <a:ea typeface="+mn-ea"/>
                          <a:cs typeface="+mn-cs"/>
                        </a:rPr>
                        <a:t>7.5</a:t>
                      </a:r>
                      <a:endParaRPr lang="zh-CN" altLang="en-US" sz="8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latin typeface="+mn-lt"/>
                          <a:ea typeface="+mn-ea"/>
                          <a:cs typeface="+mn-cs"/>
                        </a:rPr>
                        <a:t>10</a:t>
                      </a:r>
                      <a:endParaRPr lang="zh-CN" altLang="en-US" sz="8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</a:tbl>
          </a:graphicData>
        </a:graphic>
      </p:graphicFrame>
      <p:graphicFrame>
        <p:nvGraphicFramePr>
          <p:cNvPr id="6" name="表格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78545893"/>
              </p:ext>
            </p:extLst>
          </p:nvPr>
        </p:nvGraphicFramePr>
        <p:xfrm>
          <a:off x="-315416" y="1635400"/>
          <a:ext cx="1319808" cy="8640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319808"/>
              </a:tblGrid>
              <a:tr h="216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8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 Unicode MS" pitchFamily="34" charset="-122"/>
                          <a:ea typeface="Arial Unicode MS" pitchFamily="34" charset="-122"/>
                          <a:cs typeface="Arial Unicode MS" pitchFamily="34" charset="-122"/>
                        </a:rPr>
                        <a:t>Cl-PARP1</a:t>
                      </a:r>
                    </a:p>
                  </a:txBody>
                  <a:tcPr/>
                </a:tc>
              </a:tr>
              <a:tr h="216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8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 Unicode MS" pitchFamily="34" charset="-122"/>
                          <a:ea typeface="Arial Unicode MS" pitchFamily="34" charset="-122"/>
                          <a:cs typeface="Arial Unicode MS" pitchFamily="34" charset="-122"/>
                        </a:rPr>
                        <a:t>Bax</a:t>
                      </a:r>
                    </a:p>
                  </a:txBody>
                  <a:tcPr/>
                </a:tc>
              </a:tr>
              <a:tr h="216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8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 Unicode MS" pitchFamily="34" charset="-122"/>
                          <a:ea typeface="Arial Unicode MS" pitchFamily="34" charset="-122"/>
                          <a:cs typeface="Arial Unicode MS" pitchFamily="34" charset="-122"/>
                        </a:rPr>
                        <a:t>Bcl-2</a:t>
                      </a:r>
                    </a:p>
                  </a:txBody>
                  <a:tcPr/>
                </a:tc>
              </a:tr>
              <a:tr h="216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8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 Unicode MS" pitchFamily="34" charset="-122"/>
                          <a:ea typeface="Arial Unicode MS" pitchFamily="34" charset="-122"/>
                          <a:cs typeface="Arial Unicode MS" pitchFamily="34" charset="-122"/>
                        </a:rPr>
                        <a:t>GAPDH</a:t>
                      </a:r>
                    </a:p>
                  </a:txBody>
                  <a:tcPr/>
                </a:tc>
              </a:tr>
            </a:tbl>
          </a:graphicData>
        </a:graphic>
      </p:graphicFrame>
      <p:graphicFrame>
        <p:nvGraphicFramePr>
          <p:cNvPr id="20" name="表格 1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27611615"/>
              </p:ext>
            </p:extLst>
          </p:nvPr>
        </p:nvGraphicFramePr>
        <p:xfrm>
          <a:off x="692696" y="3086120"/>
          <a:ext cx="6048000" cy="5029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</a:tblGrid>
              <a:tr h="180000">
                <a:tc gridSpan="4">
                  <a:txBody>
                    <a:bodyPr/>
                    <a:lstStyle/>
                    <a:p>
                      <a:pPr algn="ctr"/>
                      <a:r>
                        <a:rPr lang="en-US" altLang="zh-CN" sz="1050" dirty="0" smtClean="0">
                          <a:latin typeface="+mn-lt"/>
                          <a:ea typeface="+mn-ea"/>
                          <a:cs typeface="+mn-cs"/>
                        </a:rPr>
                        <a:t>RKO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/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altLang="zh-CN" sz="1050" dirty="0" smtClean="0">
                          <a:latin typeface="+mn-lt"/>
                          <a:ea typeface="+mn-ea"/>
                          <a:cs typeface="+mn-cs"/>
                        </a:rPr>
                        <a:t>HCT116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/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altLang="zh-CN" sz="1050" dirty="0" smtClean="0">
                          <a:latin typeface="+mn-lt"/>
                          <a:ea typeface="+mn-ea"/>
                          <a:cs typeface="+mn-cs"/>
                        </a:rPr>
                        <a:t>DLD-1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</a:tr>
              <a:tr h="18000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 smtClean="0"/>
                        <a:t>C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 smtClean="0">
                          <a:latin typeface="+mn-lt"/>
                          <a:ea typeface="+mn-ea"/>
                          <a:cs typeface="+mn-cs"/>
                        </a:rPr>
                        <a:t>5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 smtClean="0">
                          <a:latin typeface="+mn-lt"/>
                          <a:ea typeface="+mn-ea"/>
                          <a:cs typeface="+mn-cs"/>
                        </a:rPr>
                        <a:t>7.5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 smtClean="0">
                          <a:latin typeface="+mn-lt"/>
                          <a:ea typeface="+mn-ea"/>
                          <a:cs typeface="+mn-cs"/>
                        </a:rPr>
                        <a:t>10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 smtClean="0"/>
                        <a:t>C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 smtClean="0">
                          <a:latin typeface="+mn-lt"/>
                          <a:ea typeface="+mn-ea"/>
                          <a:cs typeface="+mn-cs"/>
                        </a:rPr>
                        <a:t>5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 smtClean="0">
                          <a:latin typeface="+mn-lt"/>
                          <a:ea typeface="+mn-ea"/>
                          <a:cs typeface="+mn-cs"/>
                        </a:rPr>
                        <a:t>7.5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 smtClean="0">
                          <a:latin typeface="+mn-lt"/>
                          <a:ea typeface="+mn-ea"/>
                          <a:cs typeface="+mn-cs"/>
                        </a:rPr>
                        <a:t>10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 smtClean="0"/>
                        <a:t>C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 smtClean="0">
                          <a:latin typeface="+mn-lt"/>
                          <a:ea typeface="+mn-ea"/>
                          <a:cs typeface="+mn-cs"/>
                        </a:rPr>
                        <a:t>5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 smtClean="0">
                          <a:latin typeface="+mn-lt"/>
                          <a:ea typeface="+mn-ea"/>
                          <a:cs typeface="+mn-cs"/>
                        </a:rPr>
                        <a:t>7.5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 smtClean="0">
                          <a:latin typeface="+mn-lt"/>
                          <a:ea typeface="+mn-ea"/>
                          <a:cs typeface="+mn-cs"/>
                        </a:rPr>
                        <a:t>10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</a:tbl>
          </a:graphicData>
        </a:graphic>
      </p:graphicFrame>
      <p:graphicFrame>
        <p:nvGraphicFramePr>
          <p:cNvPr id="21" name="表格 2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75831081"/>
              </p:ext>
            </p:extLst>
          </p:nvPr>
        </p:nvGraphicFramePr>
        <p:xfrm>
          <a:off x="-603448" y="3801256"/>
          <a:ext cx="1319808" cy="30240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319808"/>
              </a:tblGrid>
              <a:tr h="756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05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 Unicode MS" pitchFamily="34" charset="-122"/>
                          <a:ea typeface="Arial Unicode MS" pitchFamily="34" charset="-122"/>
                          <a:cs typeface="Arial Unicode MS" pitchFamily="34" charset="-122"/>
                        </a:rPr>
                        <a:t>Cl-PARP1</a:t>
                      </a:r>
                    </a:p>
                  </a:txBody>
                  <a:tcPr/>
                </a:tc>
              </a:tr>
              <a:tr h="756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05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 Unicode MS" pitchFamily="34" charset="-122"/>
                          <a:ea typeface="Arial Unicode MS" pitchFamily="34" charset="-122"/>
                          <a:cs typeface="Arial Unicode MS" pitchFamily="34" charset="-122"/>
                        </a:rPr>
                        <a:t>Bax</a:t>
                      </a:r>
                    </a:p>
                  </a:txBody>
                  <a:tcPr/>
                </a:tc>
              </a:tr>
              <a:tr h="756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05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 Unicode MS" pitchFamily="34" charset="-122"/>
                          <a:ea typeface="Arial Unicode MS" pitchFamily="34" charset="-122"/>
                          <a:cs typeface="Arial Unicode MS" pitchFamily="34" charset="-122"/>
                        </a:rPr>
                        <a:t>Bcl-2</a:t>
                      </a:r>
                    </a:p>
                  </a:txBody>
                  <a:tcPr/>
                </a:tc>
              </a:tr>
              <a:tr h="756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05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 Unicode MS" pitchFamily="34" charset="-122"/>
                          <a:ea typeface="Arial Unicode MS" pitchFamily="34" charset="-122"/>
                          <a:cs typeface="Arial Unicode MS" pitchFamily="34" charset="-122"/>
                        </a:rPr>
                        <a:t>GAPDH</a:t>
                      </a:r>
                    </a:p>
                  </a:txBody>
                  <a:tcPr/>
                </a:tc>
              </a:tr>
            </a:tbl>
          </a:graphicData>
        </a:graphic>
      </p:graphicFrame>
      <p:pic>
        <p:nvPicPr>
          <p:cNvPr id="1026" name="Picture 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0000" y="5868000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0000" y="4356000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0000" y="5112000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0000" y="3600000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0" name="Picture 6"/>
          <p:cNvPicPr>
            <a:picLocks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80000" y="5868000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3" name="Picture 9"/>
          <p:cNvPicPr>
            <a:picLocks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80000" y="3600000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4" name="Picture 10"/>
          <p:cNvPicPr>
            <a:picLocks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80000" y="5112000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3" name="Picture 10"/>
          <p:cNvPicPr>
            <a:picLocks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40000" y="4356000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4" name="Picture 11"/>
          <p:cNvPicPr>
            <a:picLocks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40000" y="5112000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5" name="Picture 12"/>
          <p:cNvPicPr>
            <a:picLocks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40000" y="5868000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6" name="Picture 13"/>
          <p:cNvPicPr>
            <a:picLocks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40000" y="3600000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37" name="组合 36"/>
          <p:cNvGrpSpPr/>
          <p:nvPr/>
        </p:nvGrpSpPr>
        <p:grpSpPr>
          <a:xfrm>
            <a:off x="980728" y="1640632"/>
            <a:ext cx="4536000" cy="792000"/>
            <a:chOff x="1008000" y="8553400"/>
            <a:chExt cx="4536000" cy="792000"/>
          </a:xfrm>
        </p:grpSpPr>
        <p:pic>
          <p:nvPicPr>
            <p:cNvPr id="38" name="Picture 14"/>
            <p:cNvPicPr>
              <a:picLocks noChangeArrowheads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08000" y="8553400"/>
              <a:ext cx="1296000" cy="14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9" name="Picture 15"/>
            <p:cNvPicPr>
              <a:picLocks noChangeArrowheads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08000" y="8769400"/>
              <a:ext cx="1296000" cy="14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0" name="Picture 16"/>
            <p:cNvPicPr>
              <a:picLocks noChangeArrowheads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08000" y="8985400"/>
              <a:ext cx="1296000" cy="14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1" name="Picture 17"/>
            <p:cNvPicPr>
              <a:picLocks noChangeArrowheads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08000" y="9201400"/>
              <a:ext cx="1296000" cy="14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2" name="Picture 18"/>
            <p:cNvPicPr>
              <a:picLocks noChangeArrowheads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628000" y="8553400"/>
              <a:ext cx="1296000" cy="14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3" name="Picture 20"/>
            <p:cNvPicPr>
              <a:picLocks noChangeArrowheads="1"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628000" y="8985400"/>
              <a:ext cx="1296000" cy="14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4" name="Picture 21"/>
            <p:cNvPicPr>
              <a:picLocks noChangeArrowheads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628000" y="9201400"/>
              <a:ext cx="1296000" cy="14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5" name="Picture 22"/>
            <p:cNvPicPr>
              <a:picLocks noChangeArrowheads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48000" y="8553400"/>
              <a:ext cx="1296000" cy="14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6" name="Picture 23"/>
            <p:cNvPicPr>
              <a:picLocks noChangeArrowheads="1"/>
            </p:cNvPicPr>
            <p:nvPr/>
          </p:nvPicPr>
          <p:blipFill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48000" y="8769400"/>
              <a:ext cx="1296000" cy="14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7" name="Picture 24"/>
            <p:cNvPicPr>
              <a:picLocks noChangeArrowheads="1"/>
            </p:cNvPicPr>
            <p:nvPr/>
          </p:nvPicPr>
          <p:blipFill>
            <a:blip r:embed="rId2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48000" y="8985400"/>
              <a:ext cx="1296000" cy="14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8" name="Picture 25"/>
            <p:cNvPicPr>
              <a:picLocks noChangeArrowheads="1"/>
            </p:cNvPicPr>
            <p:nvPr/>
          </p:nvPicPr>
          <p:blipFill>
            <a:blip r:embed="rId2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48000" y="9201400"/>
              <a:ext cx="1296000" cy="14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9" name="Picture 902"/>
            <p:cNvPicPr>
              <a:picLocks noChangeArrowheads="1"/>
            </p:cNvPicPr>
            <p:nvPr/>
          </p:nvPicPr>
          <p:blipFill>
            <a:blip r:embed="rId2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628000" y="8769400"/>
              <a:ext cx="1296000" cy="14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pic>
        <p:nvPicPr>
          <p:cNvPr id="7" name="Picture 2"/>
          <p:cNvPicPr>
            <a:picLocks noChangeArrowheads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80000" y="4356000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98939396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332656" y="407205"/>
            <a:ext cx="5832648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 smtClean="0"/>
              <a:t>Original images for all relevant western blots in Figure 6D</a:t>
            </a:r>
            <a:endParaRPr lang="zh-CN" altLang="en-US" sz="1600" dirty="0"/>
          </a:p>
        </p:txBody>
      </p:sp>
      <p:graphicFrame>
        <p:nvGraphicFramePr>
          <p:cNvPr id="3" name="表格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50937158"/>
              </p:ext>
            </p:extLst>
          </p:nvPr>
        </p:nvGraphicFramePr>
        <p:xfrm>
          <a:off x="1844824" y="704528"/>
          <a:ext cx="2988000" cy="20160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28000"/>
                <a:gridCol w="720000"/>
                <a:gridCol w="684000"/>
                <a:gridCol w="756000"/>
              </a:tblGrid>
              <a:tr h="28800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latin typeface="+mn-lt"/>
                        </a:rPr>
                        <a:t>Control</a:t>
                      </a:r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latin typeface="+mn-lt"/>
                        </a:rPr>
                        <a:t>Napa</a:t>
                      </a:r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latin typeface="+mn-lt"/>
                        </a:rPr>
                        <a:t>Cyn</a:t>
                      </a:r>
                      <a:r>
                        <a:rPr lang="en-US" altLang="zh-CN" sz="1000" baseline="0" dirty="0" smtClean="0">
                          <a:latin typeface="+mn-lt"/>
                        </a:rPr>
                        <a:t>-L</a:t>
                      </a:r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err="1" smtClean="0">
                          <a:latin typeface="+mn-lt"/>
                        </a:rPr>
                        <a:t>Cyn</a:t>
                      </a:r>
                      <a:r>
                        <a:rPr lang="en-US" altLang="zh-CN" sz="1000" dirty="0" smtClean="0">
                          <a:latin typeface="+mn-lt"/>
                        </a:rPr>
                        <a:t>-H</a:t>
                      </a:r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88000"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88000"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88000"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88000"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88000"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88000"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graphicFrame>
        <p:nvGraphicFramePr>
          <p:cNvPr id="4" name="表格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13775116"/>
              </p:ext>
            </p:extLst>
          </p:nvPr>
        </p:nvGraphicFramePr>
        <p:xfrm>
          <a:off x="764704" y="884520"/>
          <a:ext cx="1152000" cy="17640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152000"/>
              </a:tblGrid>
              <a:tr h="252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000" dirty="0" smtClean="0"/>
                        <a:t>LIFR</a:t>
                      </a:r>
                      <a:endParaRPr lang="zh-CN" altLang="en-US" sz="1000" dirty="0"/>
                    </a:p>
                  </a:txBody>
                  <a:tcPr/>
                </a:tc>
              </a:tr>
              <a:tr h="252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000" dirty="0" smtClean="0"/>
                        <a:t>P-stat3</a:t>
                      </a:r>
                      <a:endParaRPr lang="zh-CN" altLang="en-US" sz="1000" dirty="0"/>
                    </a:p>
                  </a:txBody>
                  <a:tcPr/>
                </a:tc>
              </a:tr>
              <a:tr h="252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000" dirty="0" smtClean="0"/>
                        <a:t>Stat3</a:t>
                      </a:r>
                      <a:endParaRPr lang="zh-CN" altLang="en-US" sz="1000" dirty="0"/>
                    </a:p>
                  </a:txBody>
                  <a:tcPr/>
                </a:tc>
              </a:tr>
              <a:tr h="252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000" dirty="0" smtClean="0"/>
                        <a:t>Cl-PARP1</a:t>
                      </a:r>
                      <a:endParaRPr lang="zh-CN" altLang="en-US" sz="1000" dirty="0"/>
                    </a:p>
                  </a:txBody>
                  <a:tcPr/>
                </a:tc>
              </a:tr>
              <a:tr h="252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000" dirty="0" smtClean="0"/>
                        <a:t>BAX</a:t>
                      </a:r>
                      <a:endParaRPr lang="zh-CN" altLang="en-US" sz="1000" dirty="0"/>
                    </a:p>
                  </a:txBody>
                  <a:tcPr/>
                </a:tc>
              </a:tr>
              <a:tr h="252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000" dirty="0" smtClean="0"/>
                        <a:t>Bcl2</a:t>
                      </a:r>
                      <a:endParaRPr lang="zh-CN" altLang="en-US" sz="1000" dirty="0"/>
                    </a:p>
                  </a:txBody>
                  <a:tcPr/>
                </a:tc>
              </a:tr>
              <a:tr h="252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000" dirty="0" smtClean="0"/>
                        <a:t>GAPDH</a:t>
                      </a:r>
                      <a:endParaRPr lang="zh-CN" altLang="en-US" sz="1000" dirty="0"/>
                    </a:p>
                  </a:txBody>
                  <a:tcPr/>
                </a:tc>
              </a:tr>
            </a:tbl>
          </a:graphicData>
        </a:graphic>
      </p:graphicFrame>
      <p:grpSp>
        <p:nvGrpSpPr>
          <p:cNvPr id="5" name="组合 4"/>
          <p:cNvGrpSpPr/>
          <p:nvPr/>
        </p:nvGrpSpPr>
        <p:grpSpPr>
          <a:xfrm>
            <a:off x="1916832" y="956520"/>
            <a:ext cx="2916000" cy="1692000"/>
            <a:chOff x="1099517" y="5292576"/>
            <a:chExt cx="2916000" cy="1692000"/>
          </a:xfrm>
        </p:grpSpPr>
        <p:pic>
          <p:nvPicPr>
            <p:cNvPr id="6" name="Picture 4"/>
            <p:cNvPicPr>
              <a:picLocks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99517" y="5292576"/>
              <a:ext cx="2916000" cy="180000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" name="Picture 2"/>
            <p:cNvPicPr>
              <a:picLocks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V="1">
              <a:off x="1099517" y="5544576"/>
              <a:ext cx="2916000" cy="18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" name="Picture 5"/>
            <p:cNvPicPr>
              <a:picLocks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99517" y="6048576"/>
              <a:ext cx="2916000" cy="180000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9" name="Picture 3"/>
            <p:cNvPicPr>
              <a:picLocks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99517" y="6300576"/>
              <a:ext cx="2916000" cy="18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" name="Picture 4"/>
            <p:cNvPicPr>
              <a:picLocks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99517" y="6552576"/>
              <a:ext cx="2916000" cy="18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" name="Picture 137"/>
            <p:cNvPicPr>
              <a:picLocks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99517" y="6804576"/>
              <a:ext cx="2916000" cy="18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2" name="Picture 138"/>
            <p:cNvPicPr>
              <a:picLocks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99517" y="5796576"/>
              <a:ext cx="2916000" cy="18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graphicFrame>
        <p:nvGraphicFramePr>
          <p:cNvPr id="13" name="表格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78481313"/>
              </p:ext>
            </p:extLst>
          </p:nvPr>
        </p:nvGraphicFramePr>
        <p:xfrm>
          <a:off x="764704" y="3297040"/>
          <a:ext cx="5040000" cy="38160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60000"/>
                <a:gridCol w="1260000"/>
                <a:gridCol w="1260000"/>
                <a:gridCol w="1260000"/>
              </a:tblGrid>
              <a:tr h="208800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latin typeface="+mn-lt"/>
                        </a:rPr>
                        <a:t>Control</a:t>
                      </a:r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>
                      <a:noFill/>
                    </a:lnL>
                    <a:lnR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latin typeface="+mn-lt"/>
                        </a:rPr>
                        <a:t>Napa</a:t>
                      </a:r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latin typeface="+mn-lt"/>
                        </a:rPr>
                        <a:t>Cyn</a:t>
                      </a:r>
                      <a:r>
                        <a:rPr lang="en-US" altLang="zh-CN" sz="1000" baseline="0" dirty="0" smtClean="0">
                          <a:latin typeface="+mn-lt"/>
                        </a:rPr>
                        <a:t>-L</a:t>
                      </a:r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err="1" smtClean="0">
                          <a:latin typeface="+mn-lt"/>
                        </a:rPr>
                        <a:t>Cyn</a:t>
                      </a:r>
                      <a:r>
                        <a:rPr lang="en-US" altLang="zh-CN" sz="1000" dirty="0" smtClean="0">
                          <a:latin typeface="+mn-lt"/>
                        </a:rPr>
                        <a:t>-H</a:t>
                      </a:r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88000"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>
                      <a:noFill/>
                    </a:lnL>
                    <a:lnR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88000"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>
                      <a:noFill/>
                    </a:lnL>
                    <a:lnR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88000"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>
                      <a:noFill/>
                    </a:lnL>
                    <a:lnR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88000"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>
                      <a:noFill/>
                    </a:lnL>
                    <a:lnR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88000"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>
                      <a:noFill/>
                    </a:lnL>
                    <a:lnR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88000"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>
                      <a:noFill/>
                    </a:lnL>
                    <a:lnR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graphicFrame>
        <p:nvGraphicFramePr>
          <p:cNvPr id="14" name="表格 1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24452243"/>
              </p:ext>
            </p:extLst>
          </p:nvPr>
        </p:nvGraphicFramePr>
        <p:xfrm>
          <a:off x="-459432" y="3621272"/>
          <a:ext cx="1152000" cy="45360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152000"/>
              </a:tblGrid>
              <a:tr h="648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000" dirty="0" smtClean="0"/>
                        <a:t>LIFR</a:t>
                      </a:r>
                      <a:endParaRPr lang="zh-CN" altLang="en-US" sz="1000" dirty="0"/>
                    </a:p>
                  </a:txBody>
                  <a:tcPr/>
                </a:tc>
              </a:tr>
              <a:tr h="648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000" dirty="0" smtClean="0"/>
                        <a:t>P-stat3</a:t>
                      </a:r>
                      <a:endParaRPr lang="zh-CN" altLang="en-US" sz="1000" dirty="0"/>
                    </a:p>
                  </a:txBody>
                  <a:tcPr/>
                </a:tc>
              </a:tr>
              <a:tr h="648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000" dirty="0" smtClean="0"/>
                        <a:t>Stat3</a:t>
                      </a:r>
                      <a:endParaRPr lang="zh-CN" altLang="en-US" sz="1000" dirty="0"/>
                    </a:p>
                  </a:txBody>
                  <a:tcPr/>
                </a:tc>
              </a:tr>
              <a:tr h="648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000" dirty="0" smtClean="0"/>
                        <a:t>Cl-PARP1</a:t>
                      </a:r>
                      <a:endParaRPr lang="zh-CN" altLang="en-US" sz="1000" dirty="0"/>
                    </a:p>
                  </a:txBody>
                  <a:tcPr/>
                </a:tc>
              </a:tr>
              <a:tr h="648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000" dirty="0" smtClean="0"/>
                        <a:t>BAX</a:t>
                      </a:r>
                      <a:endParaRPr lang="zh-CN" altLang="en-US" sz="1000" dirty="0"/>
                    </a:p>
                  </a:txBody>
                  <a:tcPr/>
                </a:tc>
              </a:tr>
              <a:tr h="648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000" dirty="0" smtClean="0"/>
                        <a:t>Bcl2</a:t>
                      </a:r>
                      <a:endParaRPr lang="zh-CN" altLang="en-US" sz="1000" dirty="0"/>
                    </a:p>
                  </a:txBody>
                  <a:tcPr/>
                </a:tc>
              </a:tr>
              <a:tr h="648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000" dirty="0" smtClean="0"/>
                        <a:t>GAPDH</a:t>
                      </a:r>
                      <a:endParaRPr lang="zh-CN" altLang="en-US" sz="1000" dirty="0"/>
                    </a:p>
                  </a:txBody>
                  <a:tcPr/>
                </a:tc>
              </a:tr>
            </a:tbl>
          </a:graphicData>
        </a:graphic>
      </p:graphicFrame>
      <p:pic>
        <p:nvPicPr>
          <p:cNvPr id="1026" name="Picture 2"/>
          <p:cNvPicPr>
            <a:picLocks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2696" y="3512840"/>
            <a:ext cx="4968000" cy="5048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2696" y="4069482"/>
            <a:ext cx="4968000" cy="6286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2696" y="4775448"/>
            <a:ext cx="4968000" cy="609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2696" y="5457056"/>
            <a:ext cx="4968000" cy="485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0" name="Picture 6"/>
          <p:cNvPicPr>
            <a:picLocks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2696" y="5995392"/>
            <a:ext cx="4968000" cy="685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1" name="Picture 7"/>
          <p:cNvPicPr>
            <a:picLocks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2696" y="6753200"/>
            <a:ext cx="4968000" cy="609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2" name="Picture 8"/>
          <p:cNvPicPr>
            <a:picLocks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2696" y="7401272"/>
            <a:ext cx="4968000" cy="8477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2392542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0" name="表格 1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19158408"/>
              </p:ext>
            </p:extLst>
          </p:nvPr>
        </p:nvGraphicFramePr>
        <p:xfrm>
          <a:off x="692696" y="488504"/>
          <a:ext cx="6048000" cy="5029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</a:tblGrid>
              <a:tr h="180000">
                <a:tc gridSpan="4">
                  <a:txBody>
                    <a:bodyPr/>
                    <a:lstStyle/>
                    <a:p>
                      <a:pPr algn="ctr"/>
                      <a:r>
                        <a:rPr lang="en-US" altLang="zh-CN" sz="1050" dirty="0" smtClean="0">
                          <a:latin typeface="+mn-lt"/>
                          <a:ea typeface="+mn-ea"/>
                          <a:cs typeface="+mn-cs"/>
                        </a:rPr>
                        <a:t>RKO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/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altLang="zh-CN" sz="1050" dirty="0" smtClean="0">
                          <a:latin typeface="+mn-lt"/>
                          <a:ea typeface="+mn-ea"/>
                          <a:cs typeface="+mn-cs"/>
                        </a:rPr>
                        <a:t>HCT116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/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altLang="zh-CN" sz="1050" dirty="0" smtClean="0">
                          <a:latin typeface="+mn-lt"/>
                          <a:ea typeface="+mn-ea"/>
                          <a:cs typeface="+mn-cs"/>
                        </a:rPr>
                        <a:t>DLD-1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</a:tr>
              <a:tr h="18000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 smtClean="0"/>
                        <a:t>C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 smtClean="0">
                          <a:latin typeface="+mn-lt"/>
                          <a:ea typeface="+mn-ea"/>
                          <a:cs typeface="+mn-cs"/>
                        </a:rPr>
                        <a:t>5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 smtClean="0">
                          <a:latin typeface="+mn-lt"/>
                          <a:ea typeface="+mn-ea"/>
                          <a:cs typeface="+mn-cs"/>
                        </a:rPr>
                        <a:t>7.5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 smtClean="0">
                          <a:latin typeface="+mn-lt"/>
                          <a:ea typeface="+mn-ea"/>
                          <a:cs typeface="+mn-cs"/>
                        </a:rPr>
                        <a:t>10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 smtClean="0"/>
                        <a:t>C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 smtClean="0">
                          <a:latin typeface="+mn-lt"/>
                          <a:ea typeface="+mn-ea"/>
                          <a:cs typeface="+mn-cs"/>
                        </a:rPr>
                        <a:t>5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 smtClean="0">
                          <a:latin typeface="+mn-lt"/>
                          <a:ea typeface="+mn-ea"/>
                          <a:cs typeface="+mn-cs"/>
                        </a:rPr>
                        <a:t>7.5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 smtClean="0">
                          <a:latin typeface="+mn-lt"/>
                          <a:ea typeface="+mn-ea"/>
                          <a:cs typeface="+mn-cs"/>
                        </a:rPr>
                        <a:t>10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 smtClean="0"/>
                        <a:t>C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 smtClean="0">
                          <a:latin typeface="+mn-lt"/>
                          <a:ea typeface="+mn-ea"/>
                          <a:cs typeface="+mn-cs"/>
                        </a:rPr>
                        <a:t>5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 smtClean="0">
                          <a:latin typeface="+mn-lt"/>
                          <a:ea typeface="+mn-ea"/>
                          <a:cs typeface="+mn-cs"/>
                        </a:rPr>
                        <a:t>7.5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 smtClean="0">
                          <a:latin typeface="+mn-lt"/>
                          <a:ea typeface="+mn-ea"/>
                          <a:cs typeface="+mn-cs"/>
                        </a:rPr>
                        <a:t>10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</a:tbl>
          </a:graphicData>
        </a:graphic>
      </p:graphicFrame>
      <p:graphicFrame>
        <p:nvGraphicFramePr>
          <p:cNvPr id="21" name="表格 2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05275142"/>
              </p:ext>
            </p:extLst>
          </p:nvPr>
        </p:nvGraphicFramePr>
        <p:xfrm>
          <a:off x="-531440" y="992560"/>
          <a:ext cx="1319808" cy="30240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319808"/>
              </a:tblGrid>
              <a:tr h="756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05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 Unicode MS" pitchFamily="34" charset="-122"/>
                          <a:ea typeface="Arial Unicode MS" pitchFamily="34" charset="-122"/>
                          <a:cs typeface="Arial Unicode MS" pitchFamily="34" charset="-122"/>
                        </a:rPr>
                        <a:t>Cl-PARP1</a:t>
                      </a:r>
                    </a:p>
                  </a:txBody>
                  <a:tcPr/>
                </a:tc>
              </a:tr>
              <a:tr h="756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05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 Unicode MS" pitchFamily="34" charset="-122"/>
                          <a:ea typeface="Arial Unicode MS" pitchFamily="34" charset="-122"/>
                          <a:cs typeface="Arial Unicode MS" pitchFamily="34" charset="-122"/>
                        </a:rPr>
                        <a:t>Bax</a:t>
                      </a:r>
                    </a:p>
                  </a:txBody>
                  <a:tcPr/>
                </a:tc>
              </a:tr>
              <a:tr h="756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05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 Unicode MS" pitchFamily="34" charset="-122"/>
                          <a:ea typeface="Arial Unicode MS" pitchFamily="34" charset="-122"/>
                          <a:cs typeface="Arial Unicode MS" pitchFamily="34" charset="-122"/>
                        </a:rPr>
                        <a:t>Bcl-2</a:t>
                      </a:r>
                    </a:p>
                  </a:txBody>
                  <a:tcPr/>
                </a:tc>
              </a:tr>
              <a:tr h="756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05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 Unicode MS" pitchFamily="34" charset="-122"/>
                          <a:ea typeface="Arial Unicode MS" pitchFamily="34" charset="-122"/>
                          <a:cs typeface="Arial Unicode MS" pitchFamily="34" charset="-122"/>
                        </a:rPr>
                        <a:t>GAPDH</a:t>
                      </a:r>
                    </a:p>
                  </a:txBody>
                  <a:tcPr/>
                </a:tc>
              </a:tr>
            </a:tbl>
          </a:graphicData>
        </a:graphic>
      </p:graphicFrame>
      <p:graphicFrame>
        <p:nvGraphicFramePr>
          <p:cNvPr id="32" name="表格 3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73779822"/>
              </p:ext>
            </p:extLst>
          </p:nvPr>
        </p:nvGraphicFramePr>
        <p:xfrm>
          <a:off x="692696" y="4162048"/>
          <a:ext cx="6048000" cy="5029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</a:tblGrid>
              <a:tr h="180000">
                <a:tc gridSpan="4">
                  <a:txBody>
                    <a:bodyPr/>
                    <a:lstStyle/>
                    <a:p>
                      <a:pPr algn="ctr"/>
                      <a:r>
                        <a:rPr lang="en-US" altLang="zh-CN" sz="1050" dirty="0" smtClean="0">
                          <a:latin typeface="+mn-lt"/>
                          <a:ea typeface="+mn-ea"/>
                          <a:cs typeface="+mn-cs"/>
                        </a:rPr>
                        <a:t>RKO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/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altLang="zh-CN" sz="1050" dirty="0" smtClean="0">
                          <a:latin typeface="+mn-lt"/>
                          <a:ea typeface="+mn-ea"/>
                          <a:cs typeface="+mn-cs"/>
                        </a:rPr>
                        <a:t>HCT116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/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altLang="zh-CN" sz="1050" dirty="0" smtClean="0">
                          <a:latin typeface="+mn-lt"/>
                          <a:ea typeface="+mn-ea"/>
                          <a:cs typeface="+mn-cs"/>
                        </a:rPr>
                        <a:t>DLD-1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</a:tr>
              <a:tr h="18000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 smtClean="0"/>
                        <a:t>C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 smtClean="0">
                          <a:latin typeface="+mn-lt"/>
                          <a:ea typeface="+mn-ea"/>
                          <a:cs typeface="+mn-cs"/>
                        </a:rPr>
                        <a:t>5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 smtClean="0">
                          <a:latin typeface="+mn-lt"/>
                          <a:ea typeface="+mn-ea"/>
                          <a:cs typeface="+mn-cs"/>
                        </a:rPr>
                        <a:t>7.5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 smtClean="0">
                          <a:latin typeface="+mn-lt"/>
                          <a:ea typeface="+mn-ea"/>
                          <a:cs typeface="+mn-cs"/>
                        </a:rPr>
                        <a:t>10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 smtClean="0"/>
                        <a:t>C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 smtClean="0">
                          <a:latin typeface="+mn-lt"/>
                          <a:ea typeface="+mn-ea"/>
                          <a:cs typeface="+mn-cs"/>
                        </a:rPr>
                        <a:t>5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 smtClean="0">
                          <a:latin typeface="+mn-lt"/>
                          <a:ea typeface="+mn-ea"/>
                          <a:cs typeface="+mn-cs"/>
                        </a:rPr>
                        <a:t>7.5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 smtClean="0">
                          <a:latin typeface="+mn-lt"/>
                          <a:ea typeface="+mn-ea"/>
                          <a:cs typeface="+mn-cs"/>
                        </a:rPr>
                        <a:t>10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 smtClean="0"/>
                        <a:t>C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 smtClean="0">
                          <a:latin typeface="+mn-lt"/>
                          <a:ea typeface="+mn-ea"/>
                          <a:cs typeface="+mn-cs"/>
                        </a:rPr>
                        <a:t>5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 smtClean="0">
                          <a:latin typeface="+mn-lt"/>
                          <a:ea typeface="+mn-ea"/>
                          <a:cs typeface="+mn-cs"/>
                        </a:rPr>
                        <a:t>7.5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50" dirty="0" smtClean="0">
                          <a:latin typeface="+mn-lt"/>
                          <a:ea typeface="+mn-ea"/>
                          <a:cs typeface="+mn-cs"/>
                        </a:rPr>
                        <a:t>10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</a:tbl>
          </a:graphicData>
        </a:graphic>
      </p:graphicFrame>
      <p:graphicFrame>
        <p:nvGraphicFramePr>
          <p:cNvPr id="50" name="表格 4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20407742"/>
              </p:ext>
            </p:extLst>
          </p:nvPr>
        </p:nvGraphicFramePr>
        <p:xfrm>
          <a:off x="-531440" y="4808984"/>
          <a:ext cx="1319808" cy="30240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319808"/>
              </a:tblGrid>
              <a:tr h="756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05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 Unicode MS" pitchFamily="34" charset="-122"/>
                          <a:ea typeface="Arial Unicode MS" pitchFamily="34" charset="-122"/>
                          <a:cs typeface="Arial Unicode MS" pitchFamily="34" charset="-122"/>
                        </a:rPr>
                        <a:t>Cl-PARP1</a:t>
                      </a:r>
                    </a:p>
                  </a:txBody>
                  <a:tcPr/>
                </a:tc>
              </a:tr>
              <a:tr h="756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05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 Unicode MS" pitchFamily="34" charset="-122"/>
                          <a:ea typeface="Arial Unicode MS" pitchFamily="34" charset="-122"/>
                          <a:cs typeface="Arial Unicode MS" pitchFamily="34" charset="-122"/>
                        </a:rPr>
                        <a:t>Bax</a:t>
                      </a:r>
                    </a:p>
                  </a:txBody>
                  <a:tcPr/>
                </a:tc>
              </a:tr>
              <a:tr h="756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05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 Unicode MS" pitchFamily="34" charset="-122"/>
                          <a:ea typeface="Arial Unicode MS" pitchFamily="34" charset="-122"/>
                          <a:cs typeface="Arial Unicode MS" pitchFamily="34" charset="-122"/>
                        </a:rPr>
                        <a:t>Bcl-2</a:t>
                      </a:r>
                    </a:p>
                  </a:txBody>
                  <a:tcPr/>
                </a:tc>
              </a:tr>
              <a:tr h="756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05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 Unicode MS" pitchFamily="34" charset="-122"/>
                          <a:ea typeface="Arial Unicode MS" pitchFamily="34" charset="-122"/>
                          <a:cs typeface="Arial Unicode MS" pitchFamily="34" charset="-122"/>
                        </a:rPr>
                        <a:t>GAPDH</a:t>
                      </a:r>
                    </a:p>
                  </a:txBody>
                  <a:tcPr/>
                </a:tc>
              </a:tr>
            </a:tbl>
          </a:graphicData>
        </a:graphic>
      </p:graphicFrame>
      <p:pic>
        <p:nvPicPr>
          <p:cNvPr id="2" name="Picture 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6912" y="4710556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3"/>
          <p:cNvPicPr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6912" y="992640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4"/>
          <p:cNvPicPr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6912" y="3368824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" name="Picture 5"/>
          <p:cNvPicPr>
            <a:picLocks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6912" y="7113240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" name="Picture 6"/>
          <p:cNvPicPr>
            <a:picLocks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6912" y="2576816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1" name="Picture 7"/>
          <p:cNvPicPr>
            <a:picLocks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6912" y="6321232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2" name="Picture 8"/>
          <p:cNvPicPr>
            <a:picLocks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6912" y="1784728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" name="Picture 9"/>
          <p:cNvPicPr>
            <a:picLocks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6912" y="5529144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" name="Picture 10"/>
          <p:cNvPicPr>
            <a:picLocks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24944" y="4710556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5" name="Picture 11"/>
          <p:cNvPicPr>
            <a:picLocks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24944" y="992640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6" name="Picture 12"/>
          <p:cNvPicPr>
            <a:picLocks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24944" y="1784728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7" name="Picture 13"/>
          <p:cNvPicPr>
            <a:picLocks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24944" y="5529144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9" name="Picture 15"/>
          <p:cNvPicPr>
            <a:picLocks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24944" y="3368824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0" name="Picture 16"/>
          <p:cNvPicPr>
            <a:picLocks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24944" y="7113240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1" name="Picture 17"/>
          <p:cNvPicPr>
            <a:picLocks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41168" y="4710556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3" name="Picture 19"/>
          <p:cNvPicPr>
            <a:picLocks noChangeArrowheads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41168" y="992640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4" name="Picture 20"/>
          <p:cNvPicPr>
            <a:picLocks noChangeArrowheads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41168" y="2576816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5" name="Picture 21"/>
          <p:cNvPicPr>
            <a:picLocks noChangeArrowheads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41168" y="6321232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6" name="Picture 22"/>
          <p:cNvPicPr>
            <a:picLocks noChangeArrowheads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24944" y="2576816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7" name="Picture 23"/>
          <p:cNvPicPr>
            <a:picLocks noChangeArrowheads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24944" y="6321232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8" name="Picture 24"/>
          <p:cNvPicPr>
            <a:picLocks noChangeArrowheads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41168" y="1784728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9" name="Picture 25"/>
          <p:cNvPicPr>
            <a:picLocks noChangeArrowheads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41168" y="5529144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50" name="Picture 26"/>
          <p:cNvPicPr>
            <a:picLocks noChangeArrowheads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41168" y="3368824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51" name="Picture 27"/>
          <p:cNvPicPr>
            <a:picLocks noChangeArrowheads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41168" y="7113240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4324022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332656" y="407205"/>
            <a:ext cx="5832648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 smtClean="0"/>
              <a:t>Original images for all relevant western blots in Figure 4A</a:t>
            </a:r>
            <a:endParaRPr lang="zh-CN" altLang="en-US" sz="1600" dirty="0"/>
          </a:p>
        </p:txBody>
      </p:sp>
      <p:graphicFrame>
        <p:nvGraphicFramePr>
          <p:cNvPr id="3" name="表格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81317312"/>
              </p:ext>
            </p:extLst>
          </p:nvPr>
        </p:nvGraphicFramePr>
        <p:xfrm>
          <a:off x="1124744" y="776536"/>
          <a:ext cx="4536000" cy="4572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24000"/>
                <a:gridCol w="324000"/>
                <a:gridCol w="324000"/>
                <a:gridCol w="324000"/>
                <a:gridCol w="324000"/>
                <a:gridCol w="324000"/>
                <a:gridCol w="324000"/>
                <a:gridCol w="324000"/>
                <a:gridCol w="324000"/>
                <a:gridCol w="324000"/>
                <a:gridCol w="324000"/>
                <a:gridCol w="324000"/>
                <a:gridCol w="324000"/>
                <a:gridCol w="324000"/>
              </a:tblGrid>
              <a:tr h="180000">
                <a:tc gridSpan="4"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latin typeface="+mn-lt"/>
                          <a:ea typeface="+mn-ea"/>
                          <a:cs typeface="+mn-cs"/>
                        </a:rPr>
                        <a:t>RKO</a:t>
                      </a:r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/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latin typeface="+mn-lt"/>
                          <a:ea typeface="+mn-ea"/>
                          <a:cs typeface="+mn-cs"/>
                        </a:rPr>
                        <a:t>HCT116</a:t>
                      </a:r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/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latin typeface="+mn-lt"/>
                          <a:ea typeface="+mn-ea"/>
                          <a:cs typeface="+mn-cs"/>
                        </a:rPr>
                        <a:t>DLD-1</a:t>
                      </a:r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</a:tr>
              <a:tr h="18000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/>
                        <a:t>C</a:t>
                      </a:r>
                      <a:endParaRPr lang="zh-CN" altLang="en-US" sz="8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latin typeface="+mn-lt"/>
                          <a:ea typeface="+mn-ea"/>
                          <a:cs typeface="+mn-cs"/>
                        </a:rPr>
                        <a:t>5</a:t>
                      </a:r>
                      <a:endParaRPr lang="zh-CN" altLang="en-US" sz="8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latin typeface="+mn-lt"/>
                          <a:ea typeface="+mn-ea"/>
                          <a:cs typeface="+mn-cs"/>
                        </a:rPr>
                        <a:t>7.5</a:t>
                      </a:r>
                      <a:endParaRPr lang="zh-CN" altLang="en-US" sz="8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latin typeface="+mn-lt"/>
                          <a:ea typeface="+mn-ea"/>
                          <a:cs typeface="+mn-cs"/>
                        </a:rPr>
                        <a:t>10</a:t>
                      </a:r>
                      <a:endParaRPr lang="zh-CN" altLang="en-US" sz="8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8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/>
                        <a:t>C</a:t>
                      </a:r>
                      <a:endParaRPr lang="zh-CN" altLang="en-US" sz="8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latin typeface="+mn-lt"/>
                          <a:ea typeface="+mn-ea"/>
                          <a:cs typeface="+mn-cs"/>
                        </a:rPr>
                        <a:t>5</a:t>
                      </a:r>
                      <a:endParaRPr lang="zh-CN" altLang="en-US" sz="8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latin typeface="+mn-lt"/>
                          <a:ea typeface="+mn-ea"/>
                          <a:cs typeface="+mn-cs"/>
                        </a:rPr>
                        <a:t>7.5</a:t>
                      </a:r>
                      <a:endParaRPr lang="zh-CN" altLang="en-US" sz="8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latin typeface="+mn-lt"/>
                          <a:ea typeface="+mn-ea"/>
                          <a:cs typeface="+mn-cs"/>
                        </a:rPr>
                        <a:t>10</a:t>
                      </a:r>
                      <a:endParaRPr lang="zh-CN" altLang="en-US" sz="8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8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/>
                        <a:t>C</a:t>
                      </a:r>
                      <a:endParaRPr lang="zh-CN" altLang="en-US" sz="8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latin typeface="+mn-lt"/>
                          <a:ea typeface="+mn-ea"/>
                          <a:cs typeface="+mn-cs"/>
                        </a:rPr>
                        <a:t>5</a:t>
                      </a:r>
                      <a:endParaRPr lang="zh-CN" altLang="en-US" sz="8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latin typeface="+mn-lt"/>
                          <a:ea typeface="+mn-ea"/>
                          <a:cs typeface="+mn-cs"/>
                        </a:rPr>
                        <a:t>7.5</a:t>
                      </a:r>
                      <a:endParaRPr lang="zh-CN" altLang="en-US" sz="8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 smtClean="0">
                          <a:latin typeface="+mn-lt"/>
                          <a:ea typeface="+mn-ea"/>
                          <a:cs typeface="+mn-cs"/>
                        </a:rPr>
                        <a:t>10</a:t>
                      </a:r>
                      <a:endParaRPr lang="zh-CN" altLang="en-US" sz="8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</a:tbl>
          </a:graphicData>
        </a:graphic>
      </p:graphicFrame>
      <p:graphicFrame>
        <p:nvGraphicFramePr>
          <p:cNvPr id="4" name="表格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29864517"/>
              </p:ext>
            </p:extLst>
          </p:nvPr>
        </p:nvGraphicFramePr>
        <p:xfrm>
          <a:off x="-171400" y="1183432"/>
          <a:ext cx="1319808" cy="8534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319808"/>
              </a:tblGrid>
              <a:tr h="180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8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Arial Unicode MS" pitchFamily="34" charset="-122"/>
                          <a:cs typeface="Arial Unicode MS" pitchFamily="34" charset="-122"/>
                        </a:rPr>
                        <a:t>LIFR</a:t>
                      </a:r>
                    </a:p>
                  </a:txBody>
                  <a:tcPr/>
                </a:tc>
              </a:tr>
              <a:tr h="180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8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Arial Unicode MS" pitchFamily="34" charset="-122"/>
                          <a:cs typeface="Arial Unicode MS" pitchFamily="34" charset="-122"/>
                        </a:rPr>
                        <a:t>P-STAT3</a:t>
                      </a:r>
                    </a:p>
                  </a:txBody>
                  <a:tcPr/>
                </a:tc>
              </a:tr>
              <a:tr h="180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8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Arial Unicode MS" pitchFamily="34" charset="-122"/>
                          <a:cs typeface="Arial Unicode MS" pitchFamily="34" charset="-122"/>
                        </a:rPr>
                        <a:t>STAT3</a:t>
                      </a:r>
                    </a:p>
                  </a:txBody>
                  <a:tcPr/>
                </a:tc>
              </a:tr>
              <a:tr h="180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8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Arial Unicode MS" pitchFamily="34" charset="-122"/>
                          <a:cs typeface="Arial Unicode MS" pitchFamily="34" charset="-122"/>
                        </a:rPr>
                        <a:t>GAPDH</a:t>
                      </a:r>
                    </a:p>
                  </a:txBody>
                  <a:tcPr/>
                </a:tc>
              </a:tr>
            </a:tbl>
          </a:graphicData>
        </a:graphic>
      </p:graphicFrame>
      <p:graphicFrame>
        <p:nvGraphicFramePr>
          <p:cNvPr id="18" name="表格 1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2633704"/>
              </p:ext>
            </p:extLst>
          </p:nvPr>
        </p:nvGraphicFramePr>
        <p:xfrm>
          <a:off x="692696" y="2623592"/>
          <a:ext cx="6048000" cy="5029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</a:tblGrid>
              <a:tr h="180000">
                <a:tc gridSpan="4">
                  <a:txBody>
                    <a:bodyPr/>
                    <a:lstStyle/>
                    <a:p>
                      <a:pPr algn="ctr"/>
                      <a:r>
                        <a:rPr lang="en-US" altLang="zh-CN" sz="1100" dirty="0" smtClean="0">
                          <a:latin typeface="+mn-lt"/>
                          <a:ea typeface="+mn-ea"/>
                          <a:cs typeface="+mn-cs"/>
                        </a:rPr>
                        <a:t>RKO</a:t>
                      </a:r>
                      <a:endParaRPr lang="zh-CN" altLang="en-US" sz="11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1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/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altLang="zh-CN" sz="1100" dirty="0" smtClean="0">
                          <a:latin typeface="+mn-lt"/>
                          <a:ea typeface="+mn-ea"/>
                          <a:cs typeface="+mn-cs"/>
                        </a:rPr>
                        <a:t>HCT116</a:t>
                      </a:r>
                      <a:endParaRPr lang="zh-CN" altLang="en-US" sz="11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1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/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altLang="zh-CN" sz="1100" dirty="0" smtClean="0">
                          <a:latin typeface="+mn-lt"/>
                          <a:ea typeface="+mn-ea"/>
                          <a:cs typeface="+mn-cs"/>
                        </a:rPr>
                        <a:t>DLD-1</a:t>
                      </a:r>
                      <a:endParaRPr lang="zh-CN" altLang="en-US" sz="11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</a:tr>
              <a:tr h="18000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/>
                        <a:t>C</a:t>
                      </a:r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latin typeface="+mn-lt"/>
                          <a:ea typeface="+mn-ea"/>
                          <a:cs typeface="+mn-cs"/>
                        </a:rPr>
                        <a:t>5</a:t>
                      </a:r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latin typeface="+mn-lt"/>
                          <a:ea typeface="+mn-ea"/>
                          <a:cs typeface="+mn-cs"/>
                        </a:rPr>
                        <a:t>7.5</a:t>
                      </a:r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latin typeface="+mn-lt"/>
                          <a:ea typeface="+mn-ea"/>
                          <a:cs typeface="+mn-cs"/>
                        </a:rPr>
                        <a:t>10</a:t>
                      </a:r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/>
                        <a:t>C</a:t>
                      </a:r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latin typeface="+mn-lt"/>
                          <a:ea typeface="+mn-ea"/>
                          <a:cs typeface="+mn-cs"/>
                        </a:rPr>
                        <a:t>5</a:t>
                      </a:r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latin typeface="+mn-lt"/>
                          <a:ea typeface="+mn-ea"/>
                          <a:cs typeface="+mn-cs"/>
                        </a:rPr>
                        <a:t>7.5</a:t>
                      </a:r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latin typeface="+mn-lt"/>
                          <a:ea typeface="+mn-ea"/>
                          <a:cs typeface="+mn-cs"/>
                        </a:rPr>
                        <a:t>10</a:t>
                      </a:r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/>
                        <a:t>C</a:t>
                      </a:r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latin typeface="+mn-lt"/>
                          <a:ea typeface="+mn-ea"/>
                          <a:cs typeface="+mn-cs"/>
                        </a:rPr>
                        <a:t>5</a:t>
                      </a:r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latin typeface="+mn-lt"/>
                          <a:ea typeface="+mn-ea"/>
                          <a:cs typeface="+mn-cs"/>
                        </a:rPr>
                        <a:t>7.5</a:t>
                      </a:r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latin typeface="+mn-lt"/>
                          <a:ea typeface="+mn-ea"/>
                          <a:cs typeface="+mn-cs"/>
                        </a:rPr>
                        <a:t>10</a:t>
                      </a:r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</a:tbl>
          </a:graphicData>
        </a:graphic>
      </p:graphicFrame>
      <p:graphicFrame>
        <p:nvGraphicFramePr>
          <p:cNvPr id="19" name="表格 1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23426957"/>
              </p:ext>
            </p:extLst>
          </p:nvPr>
        </p:nvGraphicFramePr>
        <p:xfrm>
          <a:off x="-675456" y="3296816"/>
          <a:ext cx="1319808" cy="30240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319808"/>
              </a:tblGrid>
              <a:tr h="756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05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Arial Unicode MS" pitchFamily="34" charset="-122"/>
                          <a:cs typeface="Arial Unicode MS" pitchFamily="34" charset="-122"/>
                        </a:rPr>
                        <a:t>LIFR</a:t>
                      </a:r>
                    </a:p>
                  </a:txBody>
                  <a:tcPr/>
                </a:tc>
              </a:tr>
              <a:tr h="756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05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Arial Unicode MS" pitchFamily="34" charset="-122"/>
                          <a:cs typeface="Arial Unicode MS" pitchFamily="34" charset="-122"/>
                        </a:rPr>
                        <a:t>P-STAT3</a:t>
                      </a:r>
                    </a:p>
                  </a:txBody>
                  <a:tcPr/>
                </a:tc>
              </a:tr>
              <a:tr h="756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05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Arial Unicode MS" pitchFamily="34" charset="-122"/>
                          <a:cs typeface="Arial Unicode MS" pitchFamily="34" charset="-122"/>
                        </a:rPr>
                        <a:t>STAT3</a:t>
                      </a:r>
                    </a:p>
                  </a:txBody>
                  <a:tcPr/>
                </a:tc>
              </a:tr>
              <a:tr h="756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05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Arial Unicode MS" pitchFamily="34" charset="-122"/>
                          <a:cs typeface="Arial Unicode MS" pitchFamily="34" charset="-122"/>
                        </a:rPr>
                        <a:t>GAPDH</a:t>
                      </a:r>
                    </a:p>
                  </a:txBody>
                  <a:tcPr/>
                </a:tc>
              </a:tr>
            </a:tbl>
          </a:graphicData>
        </a:graphic>
      </p:graphicFrame>
      <p:pic>
        <p:nvPicPr>
          <p:cNvPr id="2050" name="Picture 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000" y="5364000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1" name="Picture 3"/>
          <p:cNvPicPr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000" y="3852000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2" name="Picture 4"/>
          <p:cNvPicPr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000" y="4608000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3" name="Picture 5"/>
          <p:cNvPicPr>
            <a:picLocks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000" y="3096000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4" name="Picture 6"/>
          <p:cNvPicPr>
            <a:picLocks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08000" y="3852000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5" name="Picture 7"/>
          <p:cNvPicPr>
            <a:picLocks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08000" y="4608000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6" name="Picture 8"/>
          <p:cNvPicPr>
            <a:picLocks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08000" y="5364000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7" name="Picture 9"/>
          <p:cNvPicPr>
            <a:picLocks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08000" y="3096000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9" name="Picture 11"/>
          <p:cNvPicPr>
            <a:picLocks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04000" y="3852000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61" name="Picture 13"/>
          <p:cNvPicPr>
            <a:picLocks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04000" y="4608000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62" name="Picture 14"/>
          <p:cNvPicPr>
            <a:picLocks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04000" y="5364000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63" name="Picture 15"/>
          <p:cNvPicPr>
            <a:picLocks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04000" y="3096000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20" name="组合 19"/>
          <p:cNvGrpSpPr/>
          <p:nvPr/>
        </p:nvGrpSpPr>
        <p:grpSpPr>
          <a:xfrm>
            <a:off x="1116000" y="1208584"/>
            <a:ext cx="4608000" cy="807416"/>
            <a:chOff x="1116000" y="1208584"/>
            <a:chExt cx="4608000" cy="807416"/>
          </a:xfrm>
        </p:grpSpPr>
        <p:pic>
          <p:nvPicPr>
            <p:cNvPr id="62" name="Picture 27"/>
            <p:cNvPicPr>
              <a:picLocks noChangeArrowheads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28000" y="1656000"/>
              <a:ext cx="1296000" cy="14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3" name="Picture 28"/>
            <p:cNvPicPr>
              <a:picLocks noChangeArrowheads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28000" y="1872000"/>
              <a:ext cx="1296000" cy="14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4" name="Picture 16"/>
            <p:cNvPicPr>
              <a:picLocks noChangeArrowheads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16000" y="1224000"/>
              <a:ext cx="1296000" cy="14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5" name="Picture 17"/>
            <p:cNvPicPr>
              <a:picLocks noChangeArrowheads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16000" y="1440000"/>
              <a:ext cx="1296000" cy="14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6" name="Picture 18"/>
            <p:cNvPicPr>
              <a:picLocks noChangeArrowheads="1"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16000" y="1656000"/>
              <a:ext cx="1296000" cy="14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7" name="Picture 19"/>
            <p:cNvPicPr>
              <a:picLocks noChangeArrowheads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16000" y="1872000"/>
              <a:ext cx="1296000" cy="14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8" name="Picture 20"/>
            <p:cNvPicPr>
              <a:picLocks noChangeArrowheads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772000" y="1224000"/>
              <a:ext cx="1296000" cy="14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9" name="Picture 21"/>
            <p:cNvPicPr>
              <a:picLocks noChangeArrowheads="1"/>
            </p:cNvPicPr>
            <p:nvPr/>
          </p:nvPicPr>
          <p:blipFill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772000" y="1440000"/>
              <a:ext cx="1296000" cy="14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0" name="Picture 23"/>
            <p:cNvPicPr>
              <a:picLocks noChangeArrowheads="1"/>
            </p:cNvPicPr>
            <p:nvPr/>
          </p:nvPicPr>
          <p:blipFill>
            <a:blip r:embed="rId2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772000" y="1656000"/>
              <a:ext cx="1296000" cy="14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1" name="Picture 24"/>
            <p:cNvPicPr>
              <a:picLocks noChangeArrowheads="1"/>
            </p:cNvPicPr>
            <p:nvPr/>
          </p:nvPicPr>
          <p:blipFill>
            <a:blip r:embed="rId2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772000" y="1872000"/>
              <a:ext cx="1296000" cy="14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2" name="Picture 25"/>
            <p:cNvPicPr>
              <a:picLocks noChangeArrowheads="1"/>
            </p:cNvPicPr>
            <p:nvPr/>
          </p:nvPicPr>
          <p:blipFill>
            <a:blip r:embed="rId2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28000" y="1208584"/>
              <a:ext cx="1296000" cy="14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3" name="Picture 26"/>
            <p:cNvPicPr>
              <a:picLocks noChangeArrowheads="1"/>
            </p:cNvPicPr>
            <p:nvPr/>
          </p:nvPicPr>
          <p:blipFill>
            <a:blip r:embed="rId2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28000" y="1440000"/>
              <a:ext cx="1296000" cy="14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226904837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8" name="表格 1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78722553"/>
              </p:ext>
            </p:extLst>
          </p:nvPr>
        </p:nvGraphicFramePr>
        <p:xfrm>
          <a:off x="692696" y="463688"/>
          <a:ext cx="6048000" cy="5029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</a:tblGrid>
              <a:tr h="180000">
                <a:tc gridSpan="4">
                  <a:txBody>
                    <a:bodyPr/>
                    <a:lstStyle/>
                    <a:p>
                      <a:pPr algn="ctr"/>
                      <a:r>
                        <a:rPr lang="en-US" altLang="zh-CN" sz="1100" dirty="0" smtClean="0">
                          <a:latin typeface="+mn-lt"/>
                          <a:ea typeface="+mn-ea"/>
                          <a:cs typeface="+mn-cs"/>
                        </a:rPr>
                        <a:t>RKO</a:t>
                      </a:r>
                      <a:endParaRPr lang="zh-CN" altLang="en-US" sz="11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1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/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altLang="zh-CN" sz="1100" dirty="0" smtClean="0">
                          <a:latin typeface="+mn-lt"/>
                          <a:ea typeface="+mn-ea"/>
                          <a:cs typeface="+mn-cs"/>
                        </a:rPr>
                        <a:t>HCT116</a:t>
                      </a:r>
                      <a:endParaRPr lang="zh-CN" altLang="en-US" sz="11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1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/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altLang="zh-CN" sz="1100" dirty="0" smtClean="0">
                          <a:latin typeface="+mn-lt"/>
                          <a:ea typeface="+mn-ea"/>
                          <a:cs typeface="+mn-cs"/>
                        </a:rPr>
                        <a:t>DLD-1</a:t>
                      </a:r>
                      <a:endParaRPr lang="zh-CN" altLang="en-US" sz="11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</a:tr>
              <a:tr h="18000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/>
                        <a:t>C</a:t>
                      </a:r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latin typeface="+mn-lt"/>
                          <a:ea typeface="+mn-ea"/>
                          <a:cs typeface="+mn-cs"/>
                        </a:rPr>
                        <a:t>5</a:t>
                      </a:r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latin typeface="+mn-lt"/>
                          <a:ea typeface="+mn-ea"/>
                          <a:cs typeface="+mn-cs"/>
                        </a:rPr>
                        <a:t>7.5</a:t>
                      </a:r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latin typeface="+mn-lt"/>
                          <a:ea typeface="+mn-ea"/>
                          <a:cs typeface="+mn-cs"/>
                        </a:rPr>
                        <a:t>10</a:t>
                      </a:r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/>
                        <a:t>C</a:t>
                      </a:r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latin typeface="+mn-lt"/>
                          <a:ea typeface="+mn-ea"/>
                          <a:cs typeface="+mn-cs"/>
                        </a:rPr>
                        <a:t>5</a:t>
                      </a:r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latin typeface="+mn-lt"/>
                          <a:ea typeface="+mn-ea"/>
                          <a:cs typeface="+mn-cs"/>
                        </a:rPr>
                        <a:t>7.5</a:t>
                      </a:r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latin typeface="+mn-lt"/>
                          <a:ea typeface="+mn-ea"/>
                          <a:cs typeface="+mn-cs"/>
                        </a:rPr>
                        <a:t>10</a:t>
                      </a:r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/>
                        <a:t>C</a:t>
                      </a:r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latin typeface="+mn-lt"/>
                          <a:ea typeface="+mn-ea"/>
                          <a:cs typeface="+mn-cs"/>
                        </a:rPr>
                        <a:t>5</a:t>
                      </a:r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latin typeface="+mn-lt"/>
                          <a:ea typeface="+mn-ea"/>
                          <a:cs typeface="+mn-cs"/>
                        </a:rPr>
                        <a:t>7.5</a:t>
                      </a:r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latin typeface="+mn-lt"/>
                          <a:ea typeface="+mn-ea"/>
                          <a:cs typeface="+mn-cs"/>
                        </a:rPr>
                        <a:t>10</a:t>
                      </a:r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</a:tbl>
          </a:graphicData>
        </a:graphic>
      </p:graphicFrame>
      <p:graphicFrame>
        <p:nvGraphicFramePr>
          <p:cNvPr id="19" name="表格 1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3668440"/>
              </p:ext>
            </p:extLst>
          </p:nvPr>
        </p:nvGraphicFramePr>
        <p:xfrm>
          <a:off x="-675456" y="1136912"/>
          <a:ext cx="1319808" cy="30240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319808"/>
              </a:tblGrid>
              <a:tr h="756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05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Arial Unicode MS" pitchFamily="34" charset="-122"/>
                          <a:cs typeface="Arial Unicode MS" pitchFamily="34" charset="-122"/>
                        </a:rPr>
                        <a:t>LIFR</a:t>
                      </a:r>
                    </a:p>
                  </a:txBody>
                  <a:tcPr/>
                </a:tc>
              </a:tr>
              <a:tr h="756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05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Arial Unicode MS" pitchFamily="34" charset="-122"/>
                          <a:cs typeface="Arial Unicode MS" pitchFamily="34" charset="-122"/>
                        </a:rPr>
                        <a:t>P-STAT3</a:t>
                      </a:r>
                    </a:p>
                  </a:txBody>
                  <a:tcPr/>
                </a:tc>
              </a:tr>
              <a:tr h="756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05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Arial Unicode MS" pitchFamily="34" charset="-122"/>
                          <a:cs typeface="Arial Unicode MS" pitchFamily="34" charset="-122"/>
                        </a:rPr>
                        <a:t>STAT3</a:t>
                      </a:r>
                    </a:p>
                  </a:txBody>
                  <a:tcPr/>
                </a:tc>
              </a:tr>
              <a:tr h="756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05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Arial Unicode MS" pitchFamily="34" charset="-122"/>
                          <a:cs typeface="Arial Unicode MS" pitchFamily="34" charset="-122"/>
                        </a:rPr>
                        <a:t>GAPDH</a:t>
                      </a:r>
                    </a:p>
                  </a:txBody>
                  <a:tcPr/>
                </a:tc>
              </a:tr>
            </a:tbl>
          </a:graphicData>
        </a:graphic>
      </p:graphicFrame>
      <p:graphicFrame>
        <p:nvGraphicFramePr>
          <p:cNvPr id="32" name="表格 3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95659385"/>
              </p:ext>
            </p:extLst>
          </p:nvPr>
        </p:nvGraphicFramePr>
        <p:xfrm>
          <a:off x="692696" y="4424128"/>
          <a:ext cx="6048000" cy="5029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  <a:gridCol w="432000"/>
              </a:tblGrid>
              <a:tr h="180000">
                <a:tc gridSpan="4">
                  <a:txBody>
                    <a:bodyPr/>
                    <a:lstStyle/>
                    <a:p>
                      <a:pPr algn="ctr"/>
                      <a:r>
                        <a:rPr lang="en-US" altLang="zh-CN" sz="1100" dirty="0" smtClean="0">
                          <a:latin typeface="+mn-lt"/>
                          <a:ea typeface="+mn-ea"/>
                          <a:cs typeface="+mn-cs"/>
                        </a:rPr>
                        <a:t>RKO</a:t>
                      </a:r>
                      <a:endParaRPr lang="zh-CN" altLang="en-US" sz="11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1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/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altLang="zh-CN" sz="1100" dirty="0" smtClean="0">
                          <a:latin typeface="+mn-lt"/>
                          <a:ea typeface="+mn-ea"/>
                          <a:cs typeface="+mn-cs"/>
                        </a:rPr>
                        <a:t>HCT116</a:t>
                      </a:r>
                      <a:endParaRPr lang="zh-CN" altLang="en-US" sz="11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1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/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altLang="zh-CN" sz="1100" dirty="0" smtClean="0">
                          <a:latin typeface="+mn-lt"/>
                          <a:ea typeface="+mn-ea"/>
                          <a:cs typeface="+mn-cs"/>
                        </a:rPr>
                        <a:t>DLD-1</a:t>
                      </a:r>
                      <a:endParaRPr lang="zh-CN" altLang="en-US" sz="11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</a:tr>
              <a:tr h="18000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/>
                        <a:t>C</a:t>
                      </a:r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latin typeface="+mn-lt"/>
                          <a:ea typeface="+mn-ea"/>
                          <a:cs typeface="+mn-cs"/>
                        </a:rPr>
                        <a:t>5</a:t>
                      </a:r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latin typeface="+mn-lt"/>
                          <a:ea typeface="+mn-ea"/>
                          <a:cs typeface="+mn-cs"/>
                        </a:rPr>
                        <a:t>7.5</a:t>
                      </a:r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latin typeface="+mn-lt"/>
                          <a:ea typeface="+mn-ea"/>
                          <a:cs typeface="+mn-cs"/>
                        </a:rPr>
                        <a:t>10</a:t>
                      </a:r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/>
                        <a:t>C</a:t>
                      </a:r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latin typeface="+mn-lt"/>
                          <a:ea typeface="+mn-ea"/>
                          <a:cs typeface="+mn-cs"/>
                        </a:rPr>
                        <a:t>5</a:t>
                      </a:r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latin typeface="+mn-lt"/>
                          <a:ea typeface="+mn-ea"/>
                          <a:cs typeface="+mn-cs"/>
                        </a:rPr>
                        <a:t>7.5</a:t>
                      </a:r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latin typeface="+mn-lt"/>
                          <a:ea typeface="+mn-ea"/>
                          <a:cs typeface="+mn-cs"/>
                        </a:rPr>
                        <a:t>10</a:t>
                      </a:r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/>
                        <a:t>C</a:t>
                      </a:r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latin typeface="+mn-lt"/>
                          <a:ea typeface="+mn-ea"/>
                          <a:cs typeface="+mn-cs"/>
                        </a:rPr>
                        <a:t>5</a:t>
                      </a:r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latin typeface="+mn-lt"/>
                          <a:ea typeface="+mn-ea"/>
                          <a:cs typeface="+mn-cs"/>
                        </a:rPr>
                        <a:t>7.5</a:t>
                      </a:r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latin typeface="+mn-lt"/>
                          <a:ea typeface="+mn-ea"/>
                          <a:cs typeface="+mn-cs"/>
                        </a:rPr>
                        <a:t>10</a:t>
                      </a:r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</a:tbl>
          </a:graphicData>
        </a:graphic>
      </p:graphicFrame>
      <p:graphicFrame>
        <p:nvGraphicFramePr>
          <p:cNvPr id="33" name="表格 3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92180761"/>
              </p:ext>
            </p:extLst>
          </p:nvPr>
        </p:nvGraphicFramePr>
        <p:xfrm>
          <a:off x="-675456" y="5097352"/>
          <a:ext cx="1319808" cy="30240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319808"/>
              </a:tblGrid>
              <a:tr h="756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05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Arial Unicode MS" pitchFamily="34" charset="-122"/>
                          <a:cs typeface="Arial Unicode MS" pitchFamily="34" charset="-122"/>
                        </a:rPr>
                        <a:t>LIFR</a:t>
                      </a:r>
                    </a:p>
                  </a:txBody>
                  <a:tcPr/>
                </a:tc>
              </a:tr>
              <a:tr h="756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05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Arial Unicode MS" pitchFamily="34" charset="-122"/>
                          <a:cs typeface="Arial Unicode MS" pitchFamily="34" charset="-122"/>
                        </a:rPr>
                        <a:t>P-STAT3</a:t>
                      </a:r>
                    </a:p>
                  </a:txBody>
                  <a:tcPr/>
                </a:tc>
              </a:tr>
              <a:tr h="756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05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Arial Unicode MS" pitchFamily="34" charset="-122"/>
                          <a:cs typeface="Arial Unicode MS" pitchFamily="34" charset="-122"/>
                        </a:rPr>
                        <a:t>STAT3</a:t>
                      </a:r>
                    </a:p>
                  </a:txBody>
                  <a:tcPr/>
                </a:tc>
              </a:tr>
              <a:tr h="756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05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Arial Unicode MS" pitchFamily="34" charset="-122"/>
                          <a:cs typeface="Arial Unicode MS" pitchFamily="34" charset="-122"/>
                        </a:rPr>
                        <a:t>GAPDH</a:t>
                      </a:r>
                    </a:p>
                  </a:txBody>
                  <a:tcPr/>
                </a:tc>
              </a:tr>
            </a:tbl>
          </a:graphicData>
        </a:graphic>
      </p:graphicFrame>
      <p:pic>
        <p:nvPicPr>
          <p:cNvPr id="5" name="Picture 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2896" y="3440912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5"/>
          <p:cNvPicPr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2896" y="5745088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" name="Picture 6"/>
          <p:cNvPicPr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2896" y="6537176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" name="Picture 7"/>
          <p:cNvPicPr>
            <a:picLocks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2896" y="1856736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" name="Picture 8"/>
          <p:cNvPicPr>
            <a:picLocks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2896" y="2648824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" name="Picture 9"/>
          <p:cNvPicPr>
            <a:picLocks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81128" y="1065366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" name="Picture 11"/>
          <p:cNvPicPr>
            <a:picLocks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81128" y="5745088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60" name="Picture 12"/>
          <p:cNvPicPr>
            <a:picLocks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81128" y="6537176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4" name="Picture 13"/>
          <p:cNvPicPr>
            <a:picLocks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81128" y="1856736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5" name="Picture 14"/>
          <p:cNvPicPr>
            <a:picLocks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81128" y="2648824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6" name="Picture 15"/>
          <p:cNvPicPr>
            <a:picLocks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81128" y="3440912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64" name="Picture 16"/>
          <p:cNvPicPr>
            <a:picLocks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81128" y="7329344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65" name="Picture 17"/>
          <p:cNvPicPr>
            <a:picLocks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25752" y="5745088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66" name="Picture 18"/>
          <p:cNvPicPr>
            <a:picLocks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25752" y="6537176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67" name="Picture 19"/>
          <p:cNvPicPr>
            <a:picLocks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25752" y="1856736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68" name="Picture 20"/>
          <p:cNvPicPr>
            <a:picLocks noChangeArrowheads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25752" y="2648824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69" name="Picture 21"/>
          <p:cNvPicPr>
            <a:picLocks noChangeArrowheads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25752" y="1065366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70" name="Picture 22"/>
          <p:cNvPicPr>
            <a:picLocks noChangeArrowheads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25752" y="4953080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71" name="Picture 23"/>
          <p:cNvPicPr>
            <a:picLocks noChangeArrowheads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2896" y="4953080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72" name="Picture 24"/>
          <p:cNvPicPr>
            <a:picLocks noChangeArrowheads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2896" y="1065366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73" name="Picture 25"/>
          <p:cNvPicPr>
            <a:picLocks noChangeArrowheads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25752" y="3440912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74" name="Picture 26"/>
          <p:cNvPicPr>
            <a:picLocks noChangeArrowheads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25752" y="7329344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75" name="Picture 27"/>
          <p:cNvPicPr>
            <a:picLocks noChangeArrowheads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2896" y="7329344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76" name="Picture 28"/>
          <p:cNvPicPr>
            <a:picLocks noChangeArrowheads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81128" y="4953080"/>
            <a:ext cx="1800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98800517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332656" y="407205"/>
            <a:ext cx="5832648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 smtClean="0"/>
              <a:t>Original images for all relevant western blots in Figure 4B</a:t>
            </a:r>
            <a:endParaRPr lang="zh-CN" altLang="en-US" sz="1600" dirty="0"/>
          </a:p>
        </p:txBody>
      </p:sp>
      <p:graphicFrame>
        <p:nvGraphicFramePr>
          <p:cNvPr id="3" name="表格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88867376"/>
              </p:ext>
            </p:extLst>
          </p:nvPr>
        </p:nvGraphicFramePr>
        <p:xfrm>
          <a:off x="1160888" y="992560"/>
          <a:ext cx="2160000" cy="457200"/>
        </p:xfrm>
        <a:graphic>
          <a:graphicData uri="http://schemas.openxmlformats.org/drawingml/2006/table">
            <a:tbl>
              <a:tblPr firstRow="1" bandRow="1"/>
              <a:tblGrid>
                <a:gridCol w="360000"/>
                <a:gridCol w="360000"/>
                <a:gridCol w="360000"/>
                <a:gridCol w="360000"/>
                <a:gridCol w="360000"/>
                <a:gridCol w="360000"/>
              </a:tblGrid>
              <a:tr h="0">
                <a:tc gridSpan="6"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1000" dirty="0" smtClean="0"/>
                        <a:t>DLD1</a:t>
                      </a:r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</a:tr>
              <a:tr h="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800" dirty="0" smtClean="0"/>
                        <a:t>C</a:t>
                      </a:r>
                      <a:endParaRPr lang="zh-CN" altLang="en-US" sz="8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800" dirty="0" smtClean="0"/>
                        <a:t>2h</a:t>
                      </a:r>
                      <a:endParaRPr lang="zh-CN" altLang="en-US" sz="8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800" dirty="0" smtClean="0"/>
                        <a:t>4h</a:t>
                      </a:r>
                      <a:endParaRPr lang="zh-CN" altLang="en-US" sz="8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800" dirty="0" smtClean="0"/>
                        <a:t>8h</a:t>
                      </a:r>
                      <a:endParaRPr lang="zh-CN" altLang="en-US" sz="8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800" dirty="0" smtClean="0"/>
                        <a:t>12h</a:t>
                      </a:r>
                      <a:endParaRPr lang="zh-CN" altLang="en-US" sz="8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800" dirty="0" smtClean="0"/>
                        <a:t>24h</a:t>
                      </a:r>
                      <a:endParaRPr lang="zh-CN" altLang="en-US" sz="8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4" name="表格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40155201"/>
              </p:ext>
            </p:extLst>
          </p:nvPr>
        </p:nvGraphicFramePr>
        <p:xfrm>
          <a:off x="-27384" y="1449880"/>
          <a:ext cx="1152000" cy="853440"/>
        </p:xfrm>
        <a:graphic>
          <a:graphicData uri="http://schemas.openxmlformats.org/drawingml/2006/table">
            <a:tbl>
              <a:tblPr firstRow="1" bandRow="1"/>
              <a:tblGrid>
                <a:gridCol w="1152000"/>
              </a:tblGrid>
              <a:tr h="180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8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Arial Unicode MS" pitchFamily="34" charset="-122"/>
                          <a:cs typeface="Arial Unicode MS" pitchFamily="34" charset="-122"/>
                        </a:rPr>
                        <a:t>LIFR</a:t>
                      </a:r>
                      <a:endParaRPr lang="zh-CN" altLang="en-US" sz="8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800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r"/>
                      <a:r>
                        <a:rPr lang="en-US" altLang="zh-CN" sz="8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Arial Unicode MS" pitchFamily="34" charset="-122"/>
                          <a:cs typeface="Arial Unicode MS" pitchFamily="34" charset="-122"/>
                        </a:rPr>
                        <a:t>P-STAT3</a:t>
                      </a:r>
                      <a:endParaRPr lang="zh-CN" altLang="en-US" sz="8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800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r"/>
                      <a:r>
                        <a:rPr lang="en-US" altLang="zh-CN" sz="8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Arial Unicode MS" pitchFamily="34" charset="-122"/>
                          <a:cs typeface="Arial Unicode MS" pitchFamily="34" charset="-122"/>
                        </a:rPr>
                        <a:t>STAT3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800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r"/>
                      <a:r>
                        <a:rPr lang="en-US" altLang="zh-CN" sz="8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Arial Unicode MS" pitchFamily="34" charset="-122"/>
                          <a:cs typeface="Arial Unicode MS" pitchFamily="34" charset="-122"/>
                        </a:rPr>
                        <a:t>GAPDH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5" name="表格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27471388"/>
              </p:ext>
            </p:extLst>
          </p:nvPr>
        </p:nvGraphicFramePr>
        <p:xfrm>
          <a:off x="3501248" y="992560"/>
          <a:ext cx="2160000" cy="457200"/>
        </p:xfrm>
        <a:graphic>
          <a:graphicData uri="http://schemas.openxmlformats.org/drawingml/2006/table">
            <a:tbl>
              <a:tblPr firstRow="1" bandRow="1"/>
              <a:tblGrid>
                <a:gridCol w="360000"/>
                <a:gridCol w="360000"/>
                <a:gridCol w="360000"/>
                <a:gridCol w="360000"/>
                <a:gridCol w="360000"/>
                <a:gridCol w="360000"/>
              </a:tblGrid>
              <a:tr h="0">
                <a:tc gridSpan="6"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1000" dirty="0" smtClean="0"/>
                        <a:t>RKO</a:t>
                      </a:r>
                      <a:endParaRPr lang="zh-CN" altLang="en-US" sz="10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</a:tr>
              <a:tr h="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800" dirty="0" smtClean="0"/>
                        <a:t>C</a:t>
                      </a:r>
                      <a:endParaRPr lang="zh-CN" altLang="en-US" sz="8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800" dirty="0" smtClean="0"/>
                        <a:t>2h</a:t>
                      </a:r>
                      <a:endParaRPr lang="zh-CN" altLang="en-US" sz="8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800" dirty="0" smtClean="0"/>
                        <a:t>4h</a:t>
                      </a:r>
                      <a:endParaRPr lang="zh-CN" altLang="en-US" sz="8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800" dirty="0" smtClean="0"/>
                        <a:t>8h</a:t>
                      </a:r>
                      <a:endParaRPr lang="zh-CN" altLang="en-US" sz="8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800" dirty="0" smtClean="0"/>
                        <a:t>12h</a:t>
                      </a:r>
                      <a:endParaRPr lang="zh-CN" altLang="en-US" sz="8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800" dirty="0" smtClean="0"/>
                        <a:t>24h</a:t>
                      </a:r>
                      <a:endParaRPr lang="zh-CN" altLang="en-US" sz="8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15" name="表格 1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29562749"/>
              </p:ext>
            </p:extLst>
          </p:nvPr>
        </p:nvGraphicFramePr>
        <p:xfrm>
          <a:off x="1160888" y="2922160"/>
          <a:ext cx="3024000" cy="525780"/>
        </p:xfrm>
        <a:graphic>
          <a:graphicData uri="http://schemas.openxmlformats.org/drawingml/2006/table">
            <a:tbl>
              <a:tblPr firstRow="1" bandRow="1"/>
              <a:tblGrid>
                <a:gridCol w="504000"/>
                <a:gridCol w="504000"/>
                <a:gridCol w="504000"/>
                <a:gridCol w="504000"/>
                <a:gridCol w="504000"/>
                <a:gridCol w="504000"/>
              </a:tblGrid>
              <a:tr h="0">
                <a:tc gridSpan="6"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1200" dirty="0" smtClean="0"/>
                        <a:t>DLD1</a:t>
                      </a:r>
                      <a:endParaRPr lang="zh-CN" altLang="en-US" sz="12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</a:tr>
              <a:tr h="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1050" dirty="0" smtClean="0"/>
                        <a:t>C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1050" dirty="0" smtClean="0"/>
                        <a:t>2h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1050" dirty="0" smtClean="0"/>
                        <a:t>4h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1050" dirty="0" smtClean="0"/>
                        <a:t>8h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1050" dirty="0" smtClean="0"/>
                        <a:t>12h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1050" dirty="0" smtClean="0"/>
                        <a:t>24h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16" name="表格 1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72716398"/>
              </p:ext>
            </p:extLst>
          </p:nvPr>
        </p:nvGraphicFramePr>
        <p:xfrm>
          <a:off x="-27384" y="3585056"/>
          <a:ext cx="1152000" cy="2160000"/>
        </p:xfrm>
        <a:graphic>
          <a:graphicData uri="http://schemas.openxmlformats.org/drawingml/2006/table">
            <a:tbl>
              <a:tblPr firstRow="1" bandRow="1"/>
              <a:tblGrid>
                <a:gridCol w="1152000"/>
              </a:tblGrid>
              <a:tr h="540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05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Arial Unicode MS" pitchFamily="34" charset="-122"/>
                          <a:cs typeface="Arial Unicode MS" pitchFamily="34" charset="-122"/>
                        </a:rPr>
                        <a:t>LIFR</a:t>
                      </a:r>
                      <a:endParaRPr lang="zh-CN" altLang="en-US" sz="105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5400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r"/>
                      <a:r>
                        <a:rPr lang="en-US" altLang="zh-CN" sz="105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Arial Unicode MS" pitchFamily="34" charset="-122"/>
                          <a:cs typeface="Arial Unicode MS" pitchFamily="34" charset="-122"/>
                        </a:rPr>
                        <a:t>P-STAT3</a:t>
                      </a:r>
                      <a:endParaRPr lang="zh-CN" altLang="en-US" sz="105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5400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r"/>
                      <a:r>
                        <a:rPr lang="en-US" altLang="zh-CN" sz="105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Arial Unicode MS" pitchFamily="34" charset="-122"/>
                          <a:cs typeface="Arial Unicode MS" pitchFamily="34" charset="-122"/>
                        </a:rPr>
                        <a:t>STAT3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5400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r"/>
                      <a:r>
                        <a:rPr lang="en-US" altLang="zh-CN" sz="105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Arial Unicode MS" pitchFamily="34" charset="-122"/>
                          <a:cs typeface="Arial Unicode MS" pitchFamily="34" charset="-122"/>
                        </a:rPr>
                        <a:t>GAPDH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18" name="表格 1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84134604"/>
              </p:ext>
            </p:extLst>
          </p:nvPr>
        </p:nvGraphicFramePr>
        <p:xfrm>
          <a:off x="-27384" y="6393160"/>
          <a:ext cx="1152000" cy="2016000"/>
        </p:xfrm>
        <a:graphic>
          <a:graphicData uri="http://schemas.openxmlformats.org/drawingml/2006/table">
            <a:tbl>
              <a:tblPr firstRow="1" bandRow="1"/>
              <a:tblGrid>
                <a:gridCol w="1152000"/>
              </a:tblGrid>
              <a:tr h="504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05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Arial Unicode MS" pitchFamily="34" charset="-122"/>
                          <a:cs typeface="Arial Unicode MS" pitchFamily="34" charset="-122"/>
                        </a:rPr>
                        <a:t>LIFR</a:t>
                      </a:r>
                      <a:endParaRPr lang="zh-CN" altLang="en-US" sz="105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5040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r"/>
                      <a:r>
                        <a:rPr lang="en-US" altLang="zh-CN" sz="105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Arial Unicode MS" pitchFamily="34" charset="-122"/>
                          <a:cs typeface="Arial Unicode MS" pitchFamily="34" charset="-122"/>
                        </a:rPr>
                        <a:t>P-STAT3</a:t>
                      </a:r>
                      <a:endParaRPr lang="zh-CN" altLang="en-US" sz="105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5040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r"/>
                      <a:r>
                        <a:rPr lang="en-US" altLang="zh-CN" sz="105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Arial Unicode MS" pitchFamily="34" charset="-122"/>
                          <a:cs typeface="Arial Unicode MS" pitchFamily="34" charset="-122"/>
                        </a:rPr>
                        <a:t>STAT3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5040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r"/>
                      <a:r>
                        <a:rPr lang="en-US" altLang="zh-CN" sz="105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Arial Unicode MS" pitchFamily="34" charset="-122"/>
                          <a:cs typeface="Arial Unicode MS" pitchFamily="34" charset="-122"/>
                        </a:rPr>
                        <a:t>GAPDH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19" name="表格 1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35102110"/>
              </p:ext>
            </p:extLst>
          </p:nvPr>
        </p:nvGraphicFramePr>
        <p:xfrm>
          <a:off x="1196992" y="5719936"/>
          <a:ext cx="3024000" cy="525780"/>
        </p:xfrm>
        <a:graphic>
          <a:graphicData uri="http://schemas.openxmlformats.org/drawingml/2006/table">
            <a:tbl>
              <a:tblPr firstRow="1" bandRow="1"/>
              <a:tblGrid>
                <a:gridCol w="504000"/>
                <a:gridCol w="504000"/>
                <a:gridCol w="504000"/>
                <a:gridCol w="504000"/>
                <a:gridCol w="504000"/>
                <a:gridCol w="504000"/>
              </a:tblGrid>
              <a:tr h="0">
                <a:tc gridSpan="6"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1200" dirty="0" smtClean="0"/>
                        <a:t>RKO</a:t>
                      </a:r>
                      <a:endParaRPr lang="zh-CN" altLang="en-US" sz="12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</a:tr>
              <a:tr h="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1050" dirty="0" smtClean="0"/>
                        <a:t>C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1050" dirty="0" smtClean="0"/>
                        <a:t>2h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1050" dirty="0" smtClean="0"/>
                        <a:t>4h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1050" dirty="0" smtClean="0"/>
                        <a:t>8h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1050" dirty="0" smtClean="0"/>
                        <a:t>12h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1050" dirty="0" smtClean="0"/>
                        <a:t>24h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pic>
        <p:nvPicPr>
          <p:cNvPr id="5122" name="Picture 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5806" y="3440832"/>
            <a:ext cx="3024000" cy="5715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3" name="Picture 3"/>
          <p:cNvPicPr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5806" y="4068000"/>
            <a:ext cx="3024000" cy="4286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4" name="Picture 4"/>
          <p:cNvPicPr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5806" y="4572000"/>
            <a:ext cx="3024000" cy="4286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5" name="Picture 5"/>
          <p:cNvPicPr>
            <a:picLocks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5806" y="5076000"/>
            <a:ext cx="30240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6" name="Picture 6"/>
          <p:cNvPicPr>
            <a:picLocks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5806" y="6238742"/>
            <a:ext cx="3024000" cy="523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8" name="Picture 8"/>
          <p:cNvPicPr>
            <a:picLocks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5806" y="6804000"/>
            <a:ext cx="3024000" cy="419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9" name="Picture 9"/>
          <p:cNvPicPr>
            <a:picLocks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5806" y="7262585"/>
            <a:ext cx="3024000" cy="5048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30" name="Picture 10"/>
          <p:cNvPicPr>
            <a:picLocks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5806" y="7812000"/>
            <a:ext cx="302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17" name="组合 16"/>
          <p:cNvGrpSpPr/>
          <p:nvPr/>
        </p:nvGrpSpPr>
        <p:grpSpPr>
          <a:xfrm>
            <a:off x="1188000" y="1440000"/>
            <a:ext cx="4500000" cy="828000"/>
            <a:chOff x="1188000" y="1440000"/>
            <a:chExt cx="4500000" cy="828000"/>
          </a:xfrm>
        </p:grpSpPr>
        <p:pic>
          <p:nvPicPr>
            <p:cNvPr id="3074" name="Picture 2"/>
            <p:cNvPicPr>
              <a:picLocks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88000" y="1440000"/>
              <a:ext cx="2160000" cy="18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075" name="Picture 3"/>
            <p:cNvPicPr>
              <a:picLocks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88000" y="1656000"/>
              <a:ext cx="2160000" cy="18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076" name="Picture 4"/>
            <p:cNvPicPr>
              <a:picLocks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88000" y="1872000"/>
              <a:ext cx="2160000" cy="18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077" name="Picture 5"/>
            <p:cNvPicPr>
              <a:picLocks noChangeArrowheads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88000" y="2088000"/>
              <a:ext cx="2160000" cy="18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078" name="Picture 6"/>
            <p:cNvPicPr>
              <a:picLocks noChangeArrowheads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28000" y="1440000"/>
              <a:ext cx="2160000" cy="18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079" name="Picture 7"/>
            <p:cNvPicPr>
              <a:picLocks noChangeArrowheads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28000" y="1656000"/>
              <a:ext cx="2160000" cy="18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080" name="Picture 8"/>
            <p:cNvPicPr>
              <a:picLocks noChangeArrowheads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28000" y="1872000"/>
              <a:ext cx="2160000" cy="18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081" name="Picture 9"/>
            <p:cNvPicPr>
              <a:picLocks noChangeArrowheads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28000" y="2088000"/>
              <a:ext cx="2160000" cy="18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37447317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" name="表格 1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12340396"/>
              </p:ext>
            </p:extLst>
          </p:nvPr>
        </p:nvGraphicFramePr>
        <p:xfrm>
          <a:off x="1160888" y="2922160"/>
          <a:ext cx="3024000" cy="525780"/>
        </p:xfrm>
        <a:graphic>
          <a:graphicData uri="http://schemas.openxmlformats.org/drawingml/2006/table">
            <a:tbl>
              <a:tblPr firstRow="1" bandRow="1"/>
              <a:tblGrid>
                <a:gridCol w="504000"/>
                <a:gridCol w="504000"/>
                <a:gridCol w="504000"/>
                <a:gridCol w="504000"/>
                <a:gridCol w="504000"/>
                <a:gridCol w="504000"/>
              </a:tblGrid>
              <a:tr h="0">
                <a:tc gridSpan="6"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1200" dirty="0" smtClean="0"/>
                        <a:t>DLD1</a:t>
                      </a:r>
                      <a:endParaRPr lang="zh-CN" altLang="en-US" sz="12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</a:tr>
              <a:tr h="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1050" dirty="0" smtClean="0"/>
                        <a:t>C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1050" dirty="0" smtClean="0"/>
                        <a:t>2h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1050" dirty="0" smtClean="0"/>
                        <a:t>4h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1050" dirty="0" smtClean="0"/>
                        <a:t>8h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1050" dirty="0" smtClean="0"/>
                        <a:t>12h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1050" dirty="0" smtClean="0"/>
                        <a:t>24h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16" name="表格 1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44128683"/>
              </p:ext>
            </p:extLst>
          </p:nvPr>
        </p:nvGraphicFramePr>
        <p:xfrm>
          <a:off x="44752" y="3656856"/>
          <a:ext cx="1152000" cy="2304000"/>
        </p:xfrm>
        <a:graphic>
          <a:graphicData uri="http://schemas.openxmlformats.org/drawingml/2006/table">
            <a:tbl>
              <a:tblPr firstRow="1" bandRow="1"/>
              <a:tblGrid>
                <a:gridCol w="1152000"/>
              </a:tblGrid>
              <a:tr h="576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05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Arial Unicode MS" pitchFamily="34" charset="-122"/>
                          <a:cs typeface="Arial Unicode MS" pitchFamily="34" charset="-122"/>
                        </a:rPr>
                        <a:t>LIFR</a:t>
                      </a:r>
                      <a:endParaRPr lang="zh-CN" altLang="en-US" sz="105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5760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r"/>
                      <a:r>
                        <a:rPr lang="en-US" altLang="zh-CN" sz="105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Arial Unicode MS" pitchFamily="34" charset="-122"/>
                          <a:cs typeface="Arial Unicode MS" pitchFamily="34" charset="-122"/>
                        </a:rPr>
                        <a:t>P-STAT3</a:t>
                      </a:r>
                      <a:endParaRPr lang="zh-CN" altLang="en-US" sz="105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5760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r"/>
                      <a:r>
                        <a:rPr lang="en-US" altLang="zh-CN" sz="105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Arial Unicode MS" pitchFamily="34" charset="-122"/>
                          <a:cs typeface="Arial Unicode MS" pitchFamily="34" charset="-122"/>
                        </a:rPr>
                        <a:t>STAT3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5760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r"/>
                      <a:r>
                        <a:rPr lang="en-US" altLang="zh-CN" sz="105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Arial Unicode MS" pitchFamily="34" charset="-122"/>
                          <a:cs typeface="Arial Unicode MS" pitchFamily="34" charset="-122"/>
                        </a:rPr>
                        <a:t>GAPDH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18" name="表格 1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27177905"/>
              </p:ext>
            </p:extLst>
          </p:nvPr>
        </p:nvGraphicFramePr>
        <p:xfrm>
          <a:off x="44752" y="6465424"/>
          <a:ext cx="1152000" cy="2304000"/>
        </p:xfrm>
        <a:graphic>
          <a:graphicData uri="http://schemas.openxmlformats.org/drawingml/2006/table">
            <a:tbl>
              <a:tblPr firstRow="1" bandRow="1"/>
              <a:tblGrid>
                <a:gridCol w="1152000"/>
              </a:tblGrid>
              <a:tr h="576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05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Arial Unicode MS" pitchFamily="34" charset="-122"/>
                          <a:cs typeface="Arial Unicode MS" pitchFamily="34" charset="-122"/>
                        </a:rPr>
                        <a:t>LIFR</a:t>
                      </a:r>
                      <a:endParaRPr lang="zh-CN" altLang="en-US" sz="105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5760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r"/>
                      <a:r>
                        <a:rPr lang="en-US" altLang="zh-CN" sz="105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Arial Unicode MS" pitchFamily="34" charset="-122"/>
                          <a:cs typeface="Arial Unicode MS" pitchFamily="34" charset="-122"/>
                        </a:rPr>
                        <a:t>P-STAT3</a:t>
                      </a:r>
                      <a:endParaRPr lang="zh-CN" altLang="en-US" sz="105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+mn-lt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5760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r"/>
                      <a:r>
                        <a:rPr lang="en-US" altLang="zh-CN" sz="105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Arial Unicode MS" pitchFamily="34" charset="-122"/>
                          <a:cs typeface="Arial Unicode MS" pitchFamily="34" charset="-122"/>
                        </a:rPr>
                        <a:t>STAT3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5760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r"/>
                      <a:r>
                        <a:rPr lang="en-US" altLang="zh-CN" sz="105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Arial Unicode MS" pitchFamily="34" charset="-122"/>
                          <a:cs typeface="Arial Unicode MS" pitchFamily="34" charset="-122"/>
                        </a:rPr>
                        <a:t>GAPDH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19" name="表格 1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58151702"/>
              </p:ext>
            </p:extLst>
          </p:nvPr>
        </p:nvGraphicFramePr>
        <p:xfrm>
          <a:off x="1196992" y="5719936"/>
          <a:ext cx="3024000" cy="525780"/>
        </p:xfrm>
        <a:graphic>
          <a:graphicData uri="http://schemas.openxmlformats.org/drawingml/2006/table">
            <a:tbl>
              <a:tblPr firstRow="1" bandRow="1"/>
              <a:tblGrid>
                <a:gridCol w="504000"/>
                <a:gridCol w="504000"/>
                <a:gridCol w="504000"/>
                <a:gridCol w="504000"/>
                <a:gridCol w="504000"/>
                <a:gridCol w="504000"/>
              </a:tblGrid>
              <a:tr h="0">
                <a:tc gridSpan="6"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1200" dirty="0" smtClean="0"/>
                        <a:t>RKO</a:t>
                      </a:r>
                      <a:endParaRPr lang="zh-CN" altLang="en-US" sz="120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</a:tr>
              <a:tr h="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1050" dirty="0" smtClean="0"/>
                        <a:t>C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1050" dirty="0" smtClean="0"/>
                        <a:t>2h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1050" dirty="0" smtClean="0"/>
                        <a:t>4h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1050" dirty="0" smtClean="0"/>
                        <a:t>8h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1050" dirty="0" smtClean="0"/>
                        <a:t>12h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1050" dirty="0" smtClean="0"/>
                        <a:t>24h</a:t>
                      </a:r>
                      <a:endParaRPr lang="zh-CN" altLang="en-US" sz="1050" dirty="0"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pic>
        <p:nvPicPr>
          <p:cNvPr id="6" name="Picture 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97088" y="5292000"/>
            <a:ext cx="3024000" cy="572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3"/>
          <p:cNvPicPr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97088" y="8064000"/>
            <a:ext cx="3024000" cy="572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4"/>
          <p:cNvPicPr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97088" y="6227423"/>
            <a:ext cx="3024000" cy="572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" name="Picture 6"/>
          <p:cNvPicPr>
            <a:picLocks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97088" y="6840000"/>
            <a:ext cx="3024000" cy="572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" name="Picture 8"/>
          <p:cNvPicPr>
            <a:picLocks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97088" y="7452000"/>
            <a:ext cx="3024000" cy="572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82" name="Picture 10"/>
          <p:cNvPicPr>
            <a:picLocks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97088" y="4068000"/>
            <a:ext cx="3024000" cy="572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83" name="Picture 11"/>
          <p:cNvPicPr>
            <a:picLocks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97088" y="4680000"/>
            <a:ext cx="3024000" cy="572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84" name="Picture 12"/>
          <p:cNvPicPr>
            <a:picLocks noChangeArrowheads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7892"/>
          <a:stretch/>
        </p:blipFill>
        <p:spPr bwMode="auto">
          <a:xfrm>
            <a:off x="1197088" y="3456000"/>
            <a:ext cx="3024000" cy="572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06587719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332656" y="407205"/>
            <a:ext cx="5832648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 smtClean="0"/>
              <a:t>Original images for all relevant western blots in Figure 4D</a:t>
            </a:r>
            <a:endParaRPr lang="zh-CN" altLang="en-US" sz="1600" dirty="0"/>
          </a:p>
        </p:txBody>
      </p:sp>
      <p:graphicFrame>
        <p:nvGraphicFramePr>
          <p:cNvPr id="3" name="表格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87742717"/>
              </p:ext>
            </p:extLst>
          </p:nvPr>
        </p:nvGraphicFramePr>
        <p:xfrm>
          <a:off x="2915816" y="1136576"/>
          <a:ext cx="2889448" cy="7772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57200"/>
                <a:gridCol w="2232248"/>
              </a:tblGrid>
              <a:tr h="216000">
                <a:tc>
                  <a:txBody>
                    <a:bodyPr/>
                    <a:lstStyle/>
                    <a:p>
                      <a:endParaRPr lang="zh-CN" alt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100" dirty="0" smtClean="0"/>
                        <a:t> C       IL-6      25     50</a:t>
                      </a:r>
                      <a:r>
                        <a:rPr lang="en-US" altLang="zh-CN" sz="1100" baseline="0" dirty="0" smtClean="0"/>
                        <a:t>       100</a:t>
                      </a:r>
                      <a:endParaRPr lang="zh-CN" altLang="en-US" sz="1100" dirty="0"/>
                    </a:p>
                  </a:txBody>
                  <a:tcPr/>
                </a:tc>
              </a:tr>
              <a:tr h="216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100" dirty="0" smtClean="0"/>
                        <a:t>STAT3</a:t>
                      </a:r>
                      <a:endParaRPr lang="zh-CN" alt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 sz="1100" dirty="0"/>
                    </a:p>
                  </a:txBody>
                  <a:tcPr/>
                </a:tc>
              </a:tr>
              <a:tr h="216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100" dirty="0" smtClean="0"/>
                        <a:t>GAPDH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 sz="1100" dirty="0"/>
                    </a:p>
                  </a:txBody>
                  <a:tcPr/>
                </a:tc>
              </a:tr>
            </a:tbl>
          </a:graphicData>
        </a:graphic>
      </p:graphicFrame>
      <p:graphicFrame>
        <p:nvGraphicFramePr>
          <p:cNvPr id="4" name="表格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01668834"/>
              </p:ext>
            </p:extLst>
          </p:nvPr>
        </p:nvGraphicFramePr>
        <p:xfrm>
          <a:off x="260648" y="1136576"/>
          <a:ext cx="2889448" cy="7772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64096"/>
                <a:gridCol w="2025352"/>
              </a:tblGrid>
              <a:tr h="216000">
                <a:tc>
                  <a:txBody>
                    <a:bodyPr/>
                    <a:lstStyle/>
                    <a:p>
                      <a:endParaRPr lang="zh-CN" alt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100" dirty="0" smtClean="0"/>
                        <a:t>C        IL-6       25     50</a:t>
                      </a:r>
                      <a:r>
                        <a:rPr lang="en-US" altLang="zh-CN" sz="1100" baseline="0" dirty="0" smtClean="0"/>
                        <a:t>       100</a:t>
                      </a:r>
                      <a:endParaRPr lang="zh-CN" altLang="en-US" sz="1100" dirty="0"/>
                    </a:p>
                  </a:txBody>
                  <a:tcPr/>
                </a:tc>
              </a:tr>
              <a:tr h="216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100" dirty="0" smtClean="0"/>
                        <a:t>STAT3</a:t>
                      </a:r>
                      <a:endParaRPr lang="zh-CN" alt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 sz="1100" dirty="0"/>
                    </a:p>
                  </a:txBody>
                  <a:tcPr/>
                </a:tc>
              </a:tr>
              <a:tr h="216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100" dirty="0" smtClean="0"/>
                        <a:t>Lamin B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 sz="1100" dirty="0"/>
                    </a:p>
                  </a:txBody>
                  <a:tcPr/>
                </a:tc>
              </a:tr>
            </a:tbl>
          </a:graphicData>
        </a:graphic>
      </p:graphicFrame>
      <p:graphicFrame>
        <p:nvGraphicFramePr>
          <p:cNvPr id="11" name="表格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40322109"/>
              </p:ext>
            </p:extLst>
          </p:nvPr>
        </p:nvGraphicFramePr>
        <p:xfrm>
          <a:off x="359162" y="2972114"/>
          <a:ext cx="3861926" cy="18720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53614"/>
                <a:gridCol w="2808312"/>
              </a:tblGrid>
              <a:tr h="576000">
                <a:tc>
                  <a:txBody>
                    <a:bodyPr/>
                    <a:lstStyle/>
                    <a:p>
                      <a:endParaRPr lang="zh-CN" alt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100" dirty="0" smtClean="0"/>
                        <a:t>           C        IL-6       25     50</a:t>
                      </a:r>
                      <a:r>
                        <a:rPr lang="en-US" altLang="zh-CN" sz="1100" baseline="0" dirty="0" smtClean="0"/>
                        <a:t>       100</a:t>
                      </a:r>
                      <a:endParaRPr lang="zh-CN" altLang="en-US" sz="1100" dirty="0"/>
                    </a:p>
                  </a:txBody>
                  <a:tcPr/>
                </a:tc>
              </a:tr>
              <a:tr h="648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100" dirty="0" smtClean="0"/>
                        <a:t>STAT3</a:t>
                      </a:r>
                      <a:endParaRPr lang="zh-CN" alt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 sz="1100" dirty="0"/>
                    </a:p>
                  </a:txBody>
                  <a:tcPr/>
                </a:tc>
              </a:tr>
              <a:tr h="648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100" dirty="0" smtClean="0"/>
                        <a:t>Lamin B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 sz="1100" dirty="0"/>
                    </a:p>
                  </a:txBody>
                  <a:tcPr/>
                </a:tc>
              </a:tr>
            </a:tbl>
          </a:graphicData>
        </a:graphic>
      </p:graphicFrame>
      <p:pic>
        <p:nvPicPr>
          <p:cNvPr id="4098" name="Picture 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8800" y="6249144"/>
            <a:ext cx="2412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099" name="Picture 3"/>
          <p:cNvPicPr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56792" y="4035574"/>
            <a:ext cx="2412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0" name="Picture 4"/>
          <p:cNvPicPr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8800" y="5500861"/>
            <a:ext cx="2412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2" name="Picture 6"/>
          <p:cNvPicPr>
            <a:picLocks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56792" y="3224808"/>
            <a:ext cx="2412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17" name="表格 1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35651021"/>
              </p:ext>
            </p:extLst>
          </p:nvPr>
        </p:nvGraphicFramePr>
        <p:xfrm>
          <a:off x="503178" y="5241240"/>
          <a:ext cx="3861926" cy="18720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53614"/>
                <a:gridCol w="2808312"/>
              </a:tblGrid>
              <a:tr h="576000">
                <a:tc>
                  <a:txBody>
                    <a:bodyPr/>
                    <a:lstStyle/>
                    <a:p>
                      <a:endParaRPr lang="zh-CN" alt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100" dirty="0" smtClean="0"/>
                        <a:t>           C        IL-6       25     50</a:t>
                      </a:r>
                      <a:r>
                        <a:rPr lang="en-US" altLang="zh-CN" sz="1100" baseline="0" dirty="0" smtClean="0"/>
                        <a:t>       100</a:t>
                      </a:r>
                      <a:endParaRPr lang="zh-CN" altLang="en-US" sz="1100" dirty="0"/>
                    </a:p>
                  </a:txBody>
                  <a:tcPr/>
                </a:tc>
              </a:tr>
              <a:tr h="648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100" dirty="0" smtClean="0"/>
                        <a:t>STAT3</a:t>
                      </a:r>
                      <a:endParaRPr lang="zh-CN" alt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 sz="1100" dirty="0"/>
                    </a:p>
                  </a:txBody>
                  <a:tcPr/>
                </a:tc>
              </a:tr>
              <a:tr h="648000">
                <a:tc>
                  <a:txBody>
                    <a:bodyPr/>
                    <a:lstStyle/>
                    <a:p>
                      <a:pPr algn="r"/>
                      <a:r>
                        <a:rPr lang="en-US" altLang="zh-CN" sz="1100" dirty="0" smtClean="0"/>
                        <a:t>GAPDH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 sz="1100" dirty="0"/>
                    </a:p>
                  </a:txBody>
                  <a:tcPr/>
                </a:tc>
              </a:tr>
            </a:tbl>
          </a:graphicData>
        </a:graphic>
      </p:graphicFrame>
      <p:grpSp>
        <p:nvGrpSpPr>
          <p:cNvPr id="14" name="组合 13"/>
          <p:cNvGrpSpPr/>
          <p:nvPr/>
        </p:nvGrpSpPr>
        <p:grpSpPr>
          <a:xfrm>
            <a:off x="1152000" y="1440000"/>
            <a:ext cx="4248000" cy="432000"/>
            <a:chOff x="1152000" y="1440000"/>
            <a:chExt cx="4248000" cy="432000"/>
          </a:xfrm>
        </p:grpSpPr>
        <p:pic>
          <p:nvPicPr>
            <p:cNvPr id="10" name="Picture 2"/>
            <p:cNvPicPr>
              <a:picLocks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52000" y="1440000"/>
              <a:ext cx="1800000" cy="18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2" name="Picture 3"/>
            <p:cNvPicPr>
              <a:picLocks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52000" y="1692000"/>
              <a:ext cx="1800000" cy="18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3" name="Picture 4"/>
            <p:cNvPicPr>
              <a:picLocks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00000" y="1440000"/>
              <a:ext cx="1800000" cy="18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101" name="Picture 5"/>
            <p:cNvPicPr>
              <a:picLocks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00000" y="1692000"/>
              <a:ext cx="1800000" cy="18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pic>
        <p:nvPicPr>
          <p:cNvPr id="7" name="Picture 4"/>
          <p:cNvPicPr>
            <a:picLocks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21088" y="5500861"/>
            <a:ext cx="2412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5"/>
          <p:cNvPicPr>
            <a:picLocks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21088" y="4016896"/>
            <a:ext cx="2412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" name="Picture 6"/>
          <p:cNvPicPr>
            <a:picLocks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21088" y="3224808"/>
            <a:ext cx="2412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3" name="Picture 7"/>
          <p:cNvPicPr>
            <a:picLocks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21088" y="6249144"/>
            <a:ext cx="2412000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00209399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332656" y="407205"/>
            <a:ext cx="5832648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 smtClean="0"/>
              <a:t>Original images for all relevant western blots in Figure 5A</a:t>
            </a:r>
            <a:endParaRPr lang="zh-CN" altLang="en-US" sz="1600" dirty="0"/>
          </a:p>
        </p:txBody>
      </p:sp>
      <p:graphicFrame>
        <p:nvGraphicFramePr>
          <p:cNvPr id="3" name="表格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10992206"/>
              </p:ext>
            </p:extLst>
          </p:nvPr>
        </p:nvGraphicFramePr>
        <p:xfrm>
          <a:off x="1124744" y="848544"/>
          <a:ext cx="2736000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40000"/>
                <a:gridCol w="612000"/>
                <a:gridCol w="396000"/>
                <a:gridCol w="324000"/>
                <a:gridCol w="396000"/>
                <a:gridCol w="468000"/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 smtClean="0"/>
                        <a:t>input</a:t>
                      </a:r>
                      <a:endParaRPr lang="zh-CN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200" dirty="0" smtClean="0"/>
                        <a:t>Input+</a:t>
                      </a:r>
                      <a:endParaRPr lang="zh-CN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 smtClean="0"/>
                        <a:t>IgG</a:t>
                      </a:r>
                      <a:endParaRPr lang="zh-CN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 smtClean="0"/>
                        <a:t>IP</a:t>
                      </a:r>
                      <a:endParaRPr lang="zh-CN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 smtClean="0"/>
                        <a:t>IP+</a:t>
                      </a:r>
                      <a:endParaRPr lang="zh-CN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 smtClean="0"/>
                        <a:t>IgG+</a:t>
                      </a:r>
                      <a:endParaRPr lang="zh-CN" altLang="en-US" sz="1200" dirty="0"/>
                    </a:p>
                  </a:txBody>
                  <a:tcPr/>
                </a:tc>
              </a:tr>
            </a:tbl>
          </a:graphicData>
        </a:graphic>
      </p:graphicFrame>
      <p:graphicFrame>
        <p:nvGraphicFramePr>
          <p:cNvPr id="4" name="表格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53532397"/>
              </p:ext>
            </p:extLst>
          </p:nvPr>
        </p:nvGraphicFramePr>
        <p:xfrm>
          <a:off x="3789040" y="1095475"/>
          <a:ext cx="815752" cy="7772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15752"/>
              </a:tblGrid>
              <a:tr h="252000">
                <a:tc>
                  <a:txBody>
                    <a:bodyPr/>
                    <a:lstStyle/>
                    <a:p>
                      <a:r>
                        <a:rPr lang="en-US" altLang="zh-CN" sz="1100" dirty="0" smtClean="0"/>
                        <a:t>STAT3</a:t>
                      </a:r>
                      <a:endParaRPr lang="zh-CN" altLang="en-US" sz="1100" dirty="0"/>
                    </a:p>
                  </a:txBody>
                  <a:tcPr/>
                </a:tc>
              </a:tr>
              <a:tr h="252000">
                <a:tc>
                  <a:txBody>
                    <a:bodyPr/>
                    <a:lstStyle/>
                    <a:p>
                      <a:r>
                        <a:rPr lang="en-US" altLang="zh-CN" sz="1100" dirty="0" smtClean="0"/>
                        <a:t>STAT4</a:t>
                      </a:r>
                      <a:endParaRPr lang="zh-CN" altLang="en-US" sz="1100" dirty="0"/>
                    </a:p>
                  </a:txBody>
                  <a:tcPr/>
                </a:tc>
              </a:tr>
              <a:tr h="252000">
                <a:tc>
                  <a:txBody>
                    <a:bodyPr/>
                    <a:lstStyle/>
                    <a:p>
                      <a:r>
                        <a:rPr lang="en-US" altLang="zh-CN" sz="1100" dirty="0" smtClean="0"/>
                        <a:t>LIFR</a:t>
                      </a:r>
                      <a:endParaRPr lang="zh-CN" altLang="en-US" sz="1100" dirty="0"/>
                    </a:p>
                  </a:txBody>
                  <a:tcPr/>
                </a:tc>
              </a:tr>
            </a:tbl>
          </a:graphicData>
        </a:graphic>
      </p:graphicFrame>
      <p:grpSp>
        <p:nvGrpSpPr>
          <p:cNvPr id="5" name="组合 4"/>
          <p:cNvGrpSpPr/>
          <p:nvPr/>
        </p:nvGrpSpPr>
        <p:grpSpPr>
          <a:xfrm>
            <a:off x="1340768" y="1136576"/>
            <a:ext cx="2448112" cy="680480"/>
            <a:chOff x="2276952" y="1263824"/>
            <a:chExt cx="2448112" cy="680480"/>
          </a:xfrm>
        </p:grpSpPr>
        <p:pic>
          <p:nvPicPr>
            <p:cNvPr id="6" name="Picture 2"/>
            <p:cNvPicPr>
              <a:picLocks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76952" y="1263824"/>
              <a:ext cx="720000" cy="18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" name="Picture 3"/>
            <p:cNvPicPr>
              <a:picLocks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85064" y="1263824"/>
              <a:ext cx="1440000" cy="18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" name="Picture 2"/>
            <p:cNvPicPr>
              <a:picLocks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76952" y="1764304"/>
              <a:ext cx="720000" cy="18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9" name="Picture 3"/>
            <p:cNvPicPr>
              <a:picLocks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85064" y="1764304"/>
              <a:ext cx="1440000" cy="18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" name="Picture 2"/>
            <p:cNvPicPr>
              <a:picLocks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76952" y="1512256"/>
              <a:ext cx="720000" cy="18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" name="Picture 3"/>
            <p:cNvPicPr>
              <a:picLocks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85064" y="1512256"/>
              <a:ext cx="1440000" cy="18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12" name="TextBox 11"/>
          <p:cNvSpPr txBox="1"/>
          <p:nvPr/>
        </p:nvSpPr>
        <p:spPr>
          <a:xfrm>
            <a:off x="980728" y="1108938"/>
            <a:ext cx="369332" cy="720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vert="vert270" wrap="square" rtlCol="0">
            <a:spAutoFit/>
          </a:bodyPr>
          <a:lstStyle/>
          <a:p>
            <a:pPr algn="ctr"/>
            <a:r>
              <a:rPr lang="en-US" altLang="zh-CN" sz="1200" dirty="0" smtClean="0"/>
              <a:t>IP:STAT3</a:t>
            </a:r>
            <a:endParaRPr lang="zh-CN" altLang="en-US" sz="1200" dirty="0"/>
          </a:p>
        </p:txBody>
      </p:sp>
      <p:graphicFrame>
        <p:nvGraphicFramePr>
          <p:cNvPr id="13" name="表格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02270713"/>
              </p:ext>
            </p:extLst>
          </p:nvPr>
        </p:nvGraphicFramePr>
        <p:xfrm>
          <a:off x="3981400" y="2828824"/>
          <a:ext cx="815752" cy="18360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15752"/>
              </a:tblGrid>
              <a:tr h="612000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100" dirty="0" smtClean="0"/>
                        <a:t>STAT3</a:t>
                      </a:r>
                      <a:endParaRPr lang="zh-CN" altLang="en-US" sz="1100" dirty="0"/>
                    </a:p>
                  </a:txBody>
                  <a:tcPr anchor="ctr"/>
                </a:tc>
              </a:tr>
              <a:tr h="612000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100" dirty="0" smtClean="0"/>
                        <a:t>STAT4</a:t>
                      </a:r>
                      <a:endParaRPr lang="zh-CN" altLang="en-US" sz="1100" dirty="0"/>
                    </a:p>
                  </a:txBody>
                  <a:tcPr anchor="ctr"/>
                </a:tc>
              </a:tr>
              <a:tr h="612000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100" dirty="0" smtClean="0"/>
                        <a:t>LIFR</a:t>
                      </a:r>
                      <a:endParaRPr lang="zh-CN" altLang="en-US" sz="1100" dirty="0"/>
                    </a:p>
                  </a:txBody>
                  <a:tcPr anchor="ctr"/>
                </a:tc>
              </a:tr>
            </a:tbl>
          </a:graphicData>
        </a:graphic>
      </p:graphicFrame>
      <p:graphicFrame>
        <p:nvGraphicFramePr>
          <p:cNvPr id="14" name="表格 1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47604671"/>
              </p:ext>
            </p:extLst>
          </p:nvPr>
        </p:nvGraphicFramePr>
        <p:xfrm>
          <a:off x="764704" y="2519576"/>
          <a:ext cx="3240000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84000"/>
                <a:gridCol w="684000"/>
                <a:gridCol w="468000"/>
                <a:gridCol w="468000"/>
                <a:gridCol w="468000"/>
                <a:gridCol w="468000"/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 smtClean="0"/>
                        <a:t>input</a:t>
                      </a:r>
                      <a:endParaRPr lang="zh-CN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200" dirty="0" smtClean="0"/>
                        <a:t>Input+</a:t>
                      </a:r>
                      <a:endParaRPr lang="zh-CN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1200" dirty="0" smtClean="0"/>
                        <a:t>IgG</a:t>
                      </a:r>
                      <a:endParaRPr lang="zh-CN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1200" dirty="0" smtClean="0"/>
                        <a:t>IP</a:t>
                      </a:r>
                      <a:endParaRPr lang="zh-CN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1200" dirty="0" smtClean="0"/>
                        <a:t>IP+</a:t>
                      </a:r>
                      <a:endParaRPr lang="zh-CN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1200" dirty="0" smtClean="0"/>
                        <a:t>IgG+</a:t>
                      </a:r>
                      <a:endParaRPr lang="zh-CN" altLang="en-US" sz="1200" dirty="0"/>
                    </a:p>
                  </a:txBody>
                  <a:tcPr/>
                </a:tc>
              </a:tr>
            </a:tbl>
          </a:graphicData>
        </a:graphic>
      </p:graphicFrame>
      <p:pic>
        <p:nvPicPr>
          <p:cNvPr id="3074" name="Picture 2"/>
          <p:cNvPicPr>
            <a:picLocks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0840" y="4016896"/>
            <a:ext cx="1188000" cy="561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73542" y="4112146"/>
            <a:ext cx="1692000" cy="47648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6" name="Picture 4"/>
          <p:cNvPicPr>
            <a:picLocks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0840" y="2792760"/>
            <a:ext cx="1188000" cy="5524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8" name="Picture 6"/>
          <p:cNvPicPr>
            <a:picLocks noChangeAspect="1" noChangeArrowheads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716" b="6716"/>
          <a:stretch/>
        </p:blipFill>
        <p:spPr bwMode="auto">
          <a:xfrm>
            <a:off x="2273542" y="2792738"/>
            <a:ext cx="1692000" cy="58764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9" name="Picture 7"/>
          <p:cNvPicPr>
            <a:picLocks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0840" y="3407296"/>
            <a:ext cx="1188000" cy="609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80" name="Picture 8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73542" y="3578746"/>
            <a:ext cx="1692000" cy="48043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41030418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332656" y="407205"/>
            <a:ext cx="5832648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 smtClean="0"/>
              <a:t>Original images for all relevant western blots in Figure 5B</a:t>
            </a:r>
            <a:endParaRPr lang="zh-CN" altLang="en-US" sz="1600" dirty="0"/>
          </a:p>
        </p:txBody>
      </p:sp>
      <p:graphicFrame>
        <p:nvGraphicFramePr>
          <p:cNvPr id="3" name="表格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91994492"/>
              </p:ext>
            </p:extLst>
          </p:nvPr>
        </p:nvGraphicFramePr>
        <p:xfrm>
          <a:off x="3765376" y="992560"/>
          <a:ext cx="815752" cy="7772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15752"/>
              </a:tblGrid>
              <a:tr h="252000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100" dirty="0" smtClean="0"/>
                        <a:t>STAT4</a:t>
                      </a:r>
                      <a:endParaRPr lang="zh-CN" altLang="en-US" sz="1100" dirty="0"/>
                    </a:p>
                  </a:txBody>
                  <a:tcPr/>
                </a:tc>
              </a:tr>
              <a:tr h="252000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100" dirty="0" smtClean="0"/>
                        <a:t>STAT3</a:t>
                      </a:r>
                      <a:endParaRPr lang="zh-CN" altLang="en-US" sz="1100" dirty="0"/>
                    </a:p>
                  </a:txBody>
                  <a:tcPr/>
                </a:tc>
              </a:tr>
              <a:tr h="252000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100" dirty="0" smtClean="0"/>
                        <a:t>LIFR</a:t>
                      </a:r>
                      <a:endParaRPr lang="zh-CN" altLang="en-US" sz="1100" dirty="0"/>
                    </a:p>
                  </a:txBody>
                  <a:tcPr/>
                </a:tc>
              </a:tr>
            </a:tbl>
          </a:graphicData>
        </a:graphic>
      </p:graphicFrame>
      <p:graphicFrame>
        <p:nvGraphicFramePr>
          <p:cNvPr id="4" name="表格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81169006"/>
              </p:ext>
            </p:extLst>
          </p:nvPr>
        </p:nvGraphicFramePr>
        <p:xfrm>
          <a:off x="1124744" y="776536"/>
          <a:ext cx="2736000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40000"/>
                <a:gridCol w="612000"/>
                <a:gridCol w="396000"/>
                <a:gridCol w="324000"/>
                <a:gridCol w="396000"/>
                <a:gridCol w="468000"/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 smtClean="0"/>
                        <a:t>input</a:t>
                      </a:r>
                      <a:endParaRPr lang="zh-CN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200" dirty="0" smtClean="0"/>
                        <a:t>Input+</a:t>
                      </a:r>
                      <a:endParaRPr lang="zh-CN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 smtClean="0"/>
                        <a:t>IgG</a:t>
                      </a:r>
                      <a:endParaRPr lang="zh-CN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 smtClean="0"/>
                        <a:t>IP</a:t>
                      </a:r>
                      <a:endParaRPr lang="zh-CN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 smtClean="0"/>
                        <a:t>IP+</a:t>
                      </a:r>
                      <a:endParaRPr lang="zh-CN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 smtClean="0"/>
                        <a:t>IgG+</a:t>
                      </a:r>
                      <a:endParaRPr lang="zh-CN" altLang="en-US" sz="1200" dirty="0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980728" y="992640"/>
            <a:ext cx="288000" cy="72000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altLang="zh-CN" sz="1200" dirty="0" smtClean="0"/>
              <a:t>IP:STAT4</a:t>
            </a:r>
            <a:endParaRPr lang="zh-CN" altLang="en-US" sz="1200" dirty="0"/>
          </a:p>
        </p:txBody>
      </p:sp>
      <p:graphicFrame>
        <p:nvGraphicFramePr>
          <p:cNvPr id="13" name="表格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96193167"/>
              </p:ext>
            </p:extLst>
          </p:nvPr>
        </p:nvGraphicFramePr>
        <p:xfrm>
          <a:off x="4005064" y="2828824"/>
          <a:ext cx="815752" cy="18360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15752"/>
              </a:tblGrid>
              <a:tr h="612000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100" dirty="0" smtClean="0"/>
                        <a:t>STAT4</a:t>
                      </a:r>
                      <a:endParaRPr lang="zh-CN" altLang="en-US" sz="1100" dirty="0"/>
                    </a:p>
                  </a:txBody>
                  <a:tcPr anchor="ctr"/>
                </a:tc>
              </a:tr>
              <a:tr h="612000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100" dirty="0" smtClean="0"/>
                        <a:t>STAT3</a:t>
                      </a:r>
                      <a:endParaRPr lang="zh-CN" altLang="en-US" sz="1100" dirty="0"/>
                    </a:p>
                  </a:txBody>
                  <a:tcPr anchor="ctr"/>
                </a:tc>
              </a:tr>
              <a:tr h="612000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100" dirty="0" smtClean="0"/>
                        <a:t>LIFR</a:t>
                      </a:r>
                      <a:endParaRPr lang="zh-CN" altLang="en-US" sz="1100" dirty="0"/>
                    </a:p>
                  </a:txBody>
                  <a:tcPr anchor="ctr"/>
                </a:tc>
              </a:tr>
            </a:tbl>
          </a:graphicData>
        </a:graphic>
      </p:graphicFrame>
      <p:graphicFrame>
        <p:nvGraphicFramePr>
          <p:cNvPr id="14" name="表格 1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4452034"/>
              </p:ext>
            </p:extLst>
          </p:nvPr>
        </p:nvGraphicFramePr>
        <p:xfrm>
          <a:off x="764704" y="2519576"/>
          <a:ext cx="3240000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12000"/>
                <a:gridCol w="612000"/>
                <a:gridCol w="504000"/>
                <a:gridCol w="504000"/>
                <a:gridCol w="504000"/>
                <a:gridCol w="504000"/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 smtClean="0"/>
                        <a:t>input</a:t>
                      </a:r>
                      <a:endParaRPr lang="zh-CN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200" dirty="0" smtClean="0"/>
                        <a:t>Input+</a:t>
                      </a:r>
                      <a:endParaRPr lang="zh-CN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1200" dirty="0" smtClean="0"/>
                        <a:t>IgG</a:t>
                      </a:r>
                      <a:endParaRPr lang="zh-CN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1200" dirty="0" smtClean="0"/>
                        <a:t>IP</a:t>
                      </a:r>
                      <a:endParaRPr lang="zh-CN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1200" dirty="0" smtClean="0"/>
                        <a:t>IP+</a:t>
                      </a:r>
                      <a:endParaRPr lang="zh-CN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zh-CN" sz="1200" dirty="0" smtClean="0"/>
                        <a:t>IgG+</a:t>
                      </a:r>
                      <a:endParaRPr lang="zh-CN" altLang="en-US" sz="1200" dirty="0"/>
                    </a:p>
                  </a:txBody>
                  <a:tcPr/>
                </a:tc>
              </a:tr>
            </a:tbl>
          </a:graphicData>
        </a:graphic>
      </p:graphicFrame>
      <p:pic>
        <p:nvPicPr>
          <p:cNvPr id="2050" name="Picture 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6960" y="3440832"/>
            <a:ext cx="1260000" cy="54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2" name="Picture 4"/>
          <p:cNvPicPr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73689" y="3440832"/>
            <a:ext cx="1728000" cy="54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3" name="Picture 5"/>
          <p:cNvPicPr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73689" y="2828824"/>
            <a:ext cx="1728000" cy="54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6" name="Picture 8"/>
          <p:cNvPicPr>
            <a:picLocks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6960" y="4052960"/>
            <a:ext cx="1260000" cy="54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7" name="Picture 9"/>
          <p:cNvPicPr>
            <a:picLocks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73689" y="4043976"/>
            <a:ext cx="1728000" cy="54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9" name="Picture 11"/>
          <p:cNvPicPr>
            <a:picLocks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6960" y="2844054"/>
            <a:ext cx="1260000" cy="54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15" name="组合 14"/>
          <p:cNvGrpSpPr/>
          <p:nvPr/>
        </p:nvGrpSpPr>
        <p:grpSpPr>
          <a:xfrm>
            <a:off x="1340848" y="1064568"/>
            <a:ext cx="2448191" cy="684056"/>
            <a:chOff x="1340848" y="1064568"/>
            <a:chExt cx="2448191" cy="684056"/>
          </a:xfrm>
        </p:grpSpPr>
        <p:pic>
          <p:nvPicPr>
            <p:cNvPr id="7" name="Picture 3"/>
            <p:cNvPicPr>
              <a:picLocks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40848" y="1064568"/>
              <a:ext cx="720000" cy="18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" name="Picture 4"/>
            <p:cNvPicPr>
              <a:picLocks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49039" y="1064568"/>
              <a:ext cx="1440000" cy="18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9" name="Picture 2"/>
            <p:cNvPicPr>
              <a:picLocks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40848" y="1316616"/>
              <a:ext cx="720000" cy="18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" name="Picture 4"/>
            <p:cNvPicPr>
              <a:picLocks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49039" y="1316616"/>
              <a:ext cx="1440000" cy="18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" name="Picture 2"/>
            <p:cNvPicPr>
              <a:picLocks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40848" y="1568624"/>
              <a:ext cx="720000" cy="18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122" name="Picture 2"/>
            <p:cNvPicPr>
              <a:picLocks noChangeArrowheads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49039" y="1568624"/>
              <a:ext cx="1440000" cy="18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15244098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93</TotalTime>
  <Words>390</Words>
  <Application>Microsoft Office PowerPoint</Application>
  <PresentationFormat>A4 纸张(210x297 毫米)</PresentationFormat>
  <Paragraphs>294</Paragraphs>
  <Slides>10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0</vt:i4>
      </vt:variant>
    </vt:vector>
  </HeadingPairs>
  <TitlesOfParts>
    <vt:vector size="11" baseType="lpstr"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sus</dc:creator>
  <cp:lastModifiedBy>asus</cp:lastModifiedBy>
  <cp:revision>44</cp:revision>
  <dcterms:created xsi:type="dcterms:W3CDTF">2020-09-09T08:38:03Z</dcterms:created>
  <dcterms:modified xsi:type="dcterms:W3CDTF">2020-11-01T09:43:52Z</dcterms:modified>
</cp:coreProperties>
</file>